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theme/theme2.xml" ContentType="application/vnd.openxmlformats-officedocument.them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1" r:id="rId1"/>
  </p:sldMasterIdLst>
  <p:notesMasterIdLst>
    <p:notesMasterId r:id="rId7"/>
  </p:notesMasterIdLst>
  <p:sldIdLst>
    <p:sldId id="277" r:id="rId2"/>
    <p:sldId id="284" r:id="rId3"/>
    <p:sldId id="282" r:id="rId4"/>
    <p:sldId id="281" r:id="rId5"/>
    <p:sldId id="290" r:id="rId6"/>
  </p:sldIdLst>
  <p:sldSz cx="12192000" cy="12599988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Sarah Welsh" initials="SW" lastIdx="19" clrIdx="0">
    <p:extLst>
      <p:ext uri="{19B8F6BF-5375-455C-9EA6-DF929625EA0E}">
        <p15:presenceInfo xmlns:p15="http://schemas.microsoft.com/office/powerpoint/2012/main" userId="Sarah Welsh" providerId="None"/>
      </p:ext>
    </p:extLst>
  </p:cmAuthor>
  <p:cmAuthor id="2" name="James Jones" initials="JJ" lastIdx="4" clrIdx="1">
    <p:extLst>
      <p:ext uri="{19B8F6BF-5375-455C-9EA6-DF929625EA0E}">
        <p15:presenceInfo xmlns:p15="http://schemas.microsoft.com/office/powerpoint/2012/main" userId="S::joj21@cam.ac.uk::f7a1c6da-933a-4292-90d4-70dc04936d0c" providerId="AD"/>
      </p:ext>
    </p:extLst>
  </p:cmAuthor>
  <p:cmAuthor id="3" name="Sarah Welsh" initials="SW [2]" lastIdx="1" clrIdx="2">
    <p:extLst>
      <p:ext uri="{19B8F6BF-5375-455C-9EA6-DF929625EA0E}">
        <p15:presenceInfo xmlns:p15="http://schemas.microsoft.com/office/powerpoint/2012/main" userId="S::sjw236@cam.ac.uk::5f9095c1-6734-49e9-a049-26fa7c65516b" providerId="AD"/>
      </p:ext>
    </p:extLst>
  </p:cmAuthor>
  <p:cmAuthor id="4" name="Grant Stewart" initials="GS" lastIdx="3" clrIdx="3">
    <p:extLst>
      <p:ext uri="{19B8F6BF-5375-455C-9EA6-DF929625EA0E}">
        <p15:presenceInfo xmlns:p15="http://schemas.microsoft.com/office/powerpoint/2012/main" userId="S::gds35@cam.ac.uk::22320dde-3ba4-4edd-a296-7e24f78054f2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DD85896F-10CA-6F43-A141-BDAB2D5AD7E0}" v="1" dt="2022-02-04T15:11:13.181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3009"/>
    <p:restoredTop sz="96190"/>
  </p:normalViewPr>
  <p:slideViewPr>
    <p:cSldViewPr snapToGrid="0" snapToObjects="1">
      <p:cViewPr varScale="1">
        <p:scale>
          <a:sx n="67" d="100"/>
          <a:sy n="67" d="100"/>
        </p:scale>
        <p:origin x="2984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commentAuthors" Target="commentAuthors.xml"/><Relationship Id="rId13" Type="http://schemas.microsoft.com/office/2016/11/relationships/changesInfo" Target="changesInfos/changesInfo1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Relationship Id="rId14" Type="http://schemas.microsoft.com/office/2015/10/relationships/revisionInfo" Target="revisionInfo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Grant Stewart" userId="22320dde-3ba4-4edd-a296-7e24f78054f2" providerId="ADAL" clId="{DD85896F-10CA-6F43-A141-BDAB2D5AD7E0}"/>
    <pc:docChg chg="undo custSel delSld modSld">
      <pc:chgData name="Grant Stewart" userId="22320dde-3ba4-4edd-a296-7e24f78054f2" providerId="ADAL" clId="{DD85896F-10CA-6F43-A141-BDAB2D5AD7E0}" dt="2022-02-04T15:11:38.194" v="56" actId="1076"/>
      <pc:docMkLst>
        <pc:docMk/>
      </pc:docMkLst>
      <pc:sldChg chg="modSp mod">
        <pc:chgData name="Grant Stewart" userId="22320dde-3ba4-4edd-a296-7e24f78054f2" providerId="ADAL" clId="{DD85896F-10CA-6F43-A141-BDAB2D5AD7E0}" dt="2022-02-04T13:42:37.611" v="2" actId="20577"/>
        <pc:sldMkLst>
          <pc:docMk/>
          <pc:sldMk cId="704696398" sldId="277"/>
        </pc:sldMkLst>
        <pc:spChg chg="mod">
          <ac:chgData name="Grant Stewart" userId="22320dde-3ba4-4edd-a296-7e24f78054f2" providerId="ADAL" clId="{DD85896F-10CA-6F43-A141-BDAB2D5AD7E0}" dt="2022-02-04T13:42:37.611" v="2" actId="20577"/>
          <ac:spMkLst>
            <pc:docMk/>
            <pc:sldMk cId="704696398" sldId="277"/>
            <ac:spMk id="16" creationId="{01B57EFC-0E82-4BEC-B11A-1D88C10E5794}"/>
          </ac:spMkLst>
        </pc:spChg>
      </pc:sldChg>
      <pc:sldChg chg="del">
        <pc:chgData name="Grant Stewart" userId="22320dde-3ba4-4edd-a296-7e24f78054f2" providerId="ADAL" clId="{DD85896F-10CA-6F43-A141-BDAB2D5AD7E0}" dt="2022-02-04T13:42:33.490" v="0" actId="2696"/>
        <pc:sldMkLst>
          <pc:docMk/>
          <pc:sldMk cId="1689389231" sldId="280"/>
        </pc:sldMkLst>
      </pc:sldChg>
      <pc:sldChg chg="modSp mod">
        <pc:chgData name="Grant Stewart" userId="22320dde-3ba4-4edd-a296-7e24f78054f2" providerId="ADAL" clId="{DD85896F-10CA-6F43-A141-BDAB2D5AD7E0}" dt="2022-02-04T13:42:49.131" v="8" actId="20577"/>
        <pc:sldMkLst>
          <pc:docMk/>
          <pc:sldMk cId="2580442385" sldId="281"/>
        </pc:sldMkLst>
        <pc:spChg chg="mod">
          <ac:chgData name="Grant Stewart" userId="22320dde-3ba4-4edd-a296-7e24f78054f2" providerId="ADAL" clId="{DD85896F-10CA-6F43-A141-BDAB2D5AD7E0}" dt="2022-02-04T13:42:49.131" v="8" actId="20577"/>
          <ac:spMkLst>
            <pc:docMk/>
            <pc:sldMk cId="2580442385" sldId="281"/>
            <ac:spMk id="2" creationId="{003BF590-1C3C-C245-95AA-0F2D01D01294}"/>
          </ac:spMkLst>
        </pc:spChg>
      </pc:sldChg>
      <pc:sldChg chg="modSp mod">
        <pc:chgData name="Grant Stewart" userId="22320dde-3ba4-4edd-a296-7e24f78054f2" providerId="ADAL" clId="{DD85896F-10CA-6F43-A141-BDAB2D5AD7E0}" dt="2022-02-04T13:42:45.666" v="6" actId="20577"/>
        <pc:sldMkLst>
          <pc:docMk/>
          <pc:sldMk cId="2128603470" sldId="282"/>
        </pc:sldMkLst>
        <pc:spChg chg="mod">
          <ac:chgData name="Grant Stewart" userId="22320dde-3ba4-4edd-a296-7e24f78054f2" providerId="ADAL" clId="{DD85896F-10CA-6F43-A141-BDAB2D5AD7E0}" dt="2022-02-04T13:42:45.666" v="6" actId="20577"/>
          <ac:spMkLst>
            <pc:docMk/>
            <pc:sldMk cId="2128603470" sldId="282"/>
            <ac:spMk id="4" creationId="{49CA2FF4-CDDC-A74C-B37B-94133D1C1AF1}"/>
          </ac:spMkLst>
        </pc:spChg>
      </pc:sldChg>
      <pc:sldChg chg="modSp mod">
        <pc:chgData name="Grant Stewart" userId="22320dde-3ba4-4edd-a296-7e24f78054f2" providerId="ADAL" clId="{DD85896F-10CA-6F43-A141-BDAB2D5AD7E0}" dt="2022-02-04T13:42:40.851" v="4" actId="20577"/>
        <pc:sldMkLst>
          <pc:docMk/>
          <pc:sldMk cId="3573533765" sldId="284"/>
        </pc:sldMkLst>
        <pc:spChg chg="mod">
          <ac:chgData name="Grant Stewart" userId="22320dde-3ba4-4edd-a296-7e24f78054f2" providerId="ADAL" clId="{DD85896F-10CA-6F43-A141-BDAB2D5AD7E0}" dt="2022-02-04T13:42:40.851" v="4" actId="20577"/>
          <ac:spMkLst>
            <pc:docMk/>
            <pc:sldMk cId="3573533765" sldId="284"/>
            <ac:spMk id="2" creationId="{F606CCA8-8D96-F343-B340-0615DF12C442}"/>
          </ac:spMkLst>
        </pc:spChg>
      </pc:sldChg>
      <pc:sldChg chg="delSp modSp mod">
        <pc:chgData name="Grant Stewart" userId="22320dde-3ba4-4edd-a296-7e24f78054f2" providerId="ADAL" clId="{DD85896F-10CA-6F43-A141-BDAB2D5AD7E0}" dt="2022-02-04T15:11:38.194" v="56" actId="1076"/>
        <pc:sldMkLst>
          <pc:docMk/>
          <pc:sldMk cId="1038249812" sldId="290"/>
        </pc:sldMkLst>
        <pc:spChg chg="mod topLvl">
          <ac:chgData name="Grant Stewart" userId="22320dde-3ba4-4edd-a296-7e24f78054f2" providerId="ADAL" clId="{DD85896F-10CA-6F43-A141-BDAB2D5AD7E0}" dt="2022-02-04T15:11:13.181" v="19" actId="165"/>
          <ac:spMkLst>
            <pc:docMk/>
            <pc:sldMk cId="1038249812" sldId="290"/>
            <ac:spMk id="5" creationId="{E1BA34B0-3A08-4302-9ACE-95D6CC444D54}"/>
          </ac:spMkLst>
        </pc:spChg>
        <pc:spChg chg="mod">
          <ac:chgData name="Grant Stewart" userId="22320dde-3ba4-4edd-a296-7e24f78054f2" providerId="ADAL" clId="{DD85896F-10CA-6F43-A141-BDAB2D5AD7E0}" dt="2022-02-04T13:42:53.777" v="10" actId="20577"/>
          <ac:spMkLst>
            <pc:docMk/>
            <pc:sldMk cId="1038249812" sldId="290"/>
            <ac:spMk id="6" creationId="{E1843F71-58A3-43D7-BC53-B80B7428EE41}"/>
          </ac:spMkLst>
        </pc:spChg>
        <pc:spChg chg="mod topLvl">
          <ac:chgData name="Grant Stewart" userId="22320dde-3ba4-4edd-a296-7e24f78054f2" providerId="ADAL" clId="{DD85896F-10CA-6F43-A141-BDAB2D5AD7E0}" dt="2022-02-04T15:11:38.194" v="56" actId="1076"/>
          <ac:spMkLst>
            <pc:docMk/>
            <pc:sldMk cId="1038249812" sldId="290"/>
            <ac:spMk id="8" creationId="{6AA68C95-94A2-4D7A-BD57-013CFB455A2C}"/>
          </ac:spMkLst>
        </pc:spChg>
        <pc:spChg chg="mod topLvl">
          <ac:chgData name="Grant Stewart" userId="22320dde-3ba4-4edd-a296-7e24f78054f2" providerId="ADAL" clId="{DD85896F-10CA-6F43-A141-BDAB2D5AD7E0}" dt="2022-02-04T15:11:38.194" v="56" actId="1076"/>
          <ac:spMkLst>
            <pc:docMk/>
            <pc:sldMk cId="1038249812" sldId="290"/>
            <ac:spMk id="9" creationId="{68001EEF-2B18-4631-92B5-DDA86B56BFA9}"/>
          </ac:spMkLst>
        </pc:spChg>
        <pc:spChg chg="mod topLvl">
          <ac:chgData name="Grant Stewart" userId="22320dde-3ba4-4edd-a296-7e24f78054f2" providerId="ADAL" clId="{DD85896F-10CA-6F43-A141-BDAB2D5AD7E0}" dt="2022-02-04T15:11:21.648" v="55" actId="1038"/>
          <ac:spMkLst>
            <pc:docMk/>
            <pc:sldMk cId="1038249812" sldId="290"/>
            <ac:spMk id="12" creationId="{7F6FD771-43E5-48E0-9560-D158C1FE5203}"/>
          </ac:spMkLst>
        </pc:spChg>
        <pc:spChg chg="mod topLvl">
          <ac:chgData name="Grant Stewart" userId="22320dde-3ba4-4edd-a296-7e24f78054f2" providerId="ADAL" clId="{DD85896F-10CA-6F43-A141-BDAB2D5AD7E0}" dt="2022-02-04T15:11:21.648" v="55" actId="1038"/>
          <ac:spMkLst>
            <pc:docMk/>
            <pc:sldMk cId="1038249812" sldId="290"/>
            <ac:spMk id="13" creationId="{3AD1B47B-221C-45E0-AB15-25A3EAA5AE3A}"/>
          </ac:spMkLst>
        </pc:spChg>
        <pc:grpChg chg="del mod">
          <ac:chgData name="Grant Stewart" userId="22320dde-3ba4-4edd-a296-7e24f78054f2" providerId="ADAL" clId="{DD85896F-10CA-6F43-A141-BDAB2D5AD7E0}" dt="2022-02-04T15:11:13.181" v="19" actId="165"/>
          <ac:grpSpMkLst>
            <pc:docMk/>
            <pc:sldMk cId="1038249812" sldId="290"/>
            <ac:grpSpMk id="7" creationId="{A534D473-32B7-4744-AC9A-3CC026371139}"/>
          </ac:grpSpMkLst>
        </pc:grpChg>
        <pc:picChg chg="mod topLvl">
          <ac:chgData name="Grant Stewart" userId="22320dde-3ba4-4edd-a296-7e24f78054f2" providerId="ADAL" clId="{DD85896F-10CA-6F43-A141-BDAB2D5AD7E0}" dt="2022-02-04T15:11:13.181" v="19" actId="165"/>
          <ac:picMkLst>
            <pc:docMk/>
            <pc:sldMk cId="1038249812" sldId="290"/>
            <ac:picMk id="2" creationId="{75530666-B18D-48EF-B657-D17261B9CE6C}"/>
          </ac:picMkLst>
        </pc:picChg>
        <pc:picChg chg="mod topLvl">
          <ac:chgData name="Grant Stewart" userId="22320dde-3ba4-4edd-a296-7e24f78054f2" providerId="ADAL" clId="{DD85896F-10CA-6F43-A141-BDAB2D5AD7E0}" dt="2022-02-04T15:11:38.194" v="56" actId="1076"/>
          <ac:picMkLst>
            <pc:docMk/>
            <pc:sldMk cId="1038249812" sldId="290"/>
            <ac:picMk id="3" creationId="{95207DC9-B35D-4CFB-ADC4-E585D11C01D6}"/>
          </ac:picMkLst>
        </pc:picChg>
        <pc:picChg chg="mod topLvl">
          <ac:chgData name="Grant Stewart" userId="22320dde-3ba4-4edd-a296-7e24f78054f2" providerId="ADAL" clId="{DD85896F-10CA-6F43-A141-BDAB2D5AD7E0}" dt="2022-02-04T15:11:38.194" v="56" actId="1076"/>
          <ac:picMkLst>
            <pc:docMk/>
            <pc:sldMk cId="1038249812" sldId="290"/>
            <ac:picMk id="4" creationId="{4F2FAE37-155B-4939-9448-9B8E1E1DBF05}"/>
          </ac:picMkLst>
        </pc:picChg>
        <pc:picChg chg="mod topLvl">
          <ac:chgData name="Grant Stewart" userId="22320dde-3ba4-4edd-a296-7e24f78054f2" providerId="ADAL" clId="{DD85896F-10CA-6F43-A141-BDAB2D5AD7E0}" dt="2022-02-04T15:11:21.648" v="55" actId="1038"/>
          <ac:picMkLst>
            <pc:docMk/>
            <pc:sldMk cId="1038249812" sldId="290"/>
            <ac:picMk id="10" creationId="{9478BF54-5A0E-49BF-A7F2-72279B44DF47}"/>
          </ac:picMkLst>
        </pc:picChg>
        <pc:picChg chg="mod topLvl">
          <ac:chgData name="Grant Stewart" userId="22320dde-3ba4-4edd-a296-7e24f78054f2" providerId="ADAL" clId="{DD85896F-10CA-6F43-A141-BDAB2D5AD7E0}" dt="2022-02-04T15:11:21.648" v="55" actId="1038"/>
          <ac:picMkLst>
            <pc:docMk/>
            <pc:sldMk cId="1038249812" sldId="290"/>
            <ac:picMk id="11" creationId="{3165A641-BFD4-4ED2-ADD3-AAFAC745C803}"/>
          </ac:picMkLst>
        </pc:picChg>
      </pc:sldChg>
    </pc:docChg>
  </pc:docChgLst>
  <pc:docChgLst>
    <pc:chgData name="Grant Stewart" userId="22320dde-3ba4-4edd-a296-7e24f78054f2" providerId="ADAL" clId="{5E6E020B-B69D-D744-8D17-2736B9589B6F}"/>
    <pc:docChg chg="addSld delSld modSld sldOrd">
      <pc:chgData name="Grant Stewart" userId="22320dde-3ba4-4edd-a296-7e24f78054f2" providerId="ADAL" clId="{5E6E020B-B69D-D744-8D17-2736B9589B6F}" dt="2021-10-31T17:05:58.851" v="27" actId="20577"/>
      <pc:docMkLst>
        <pc:docMk/>
      </pc:docMkLst>
      <pc:sldChg chg="modSp mod">
        <pc:chgData name="Grant Stewart" userId="22320dde-3ba4-4edd-a296-7e24f78054f2" providerId="ADAL" clId="{5E6E020B-B69D-D744-8D17-2736B9589B6F}" dt="2021-10-31T17:05:26.218" v="17" actId="20577"/>
        <pc:sldMkLst>
          <pc:docMk/>
          <pc:sldMk cId="704696398" sldId="277"/>
        </pc:sldMkLst>
        <pc:spChg chg="mod">
          <ac:chgData name="Grant Stewart" userId="22320dde-3ba4-4edd-a296-7e24f78054f2" providerId="ADAL" clId="{5E6E020B-B69D-D744-8D17-2736B9589B6F}" dt="2021-10-31T17:05:26.218" v="17" actId="20577"/>
          <ac:spMkLst>
            <pc:docMk/>
            <pc:sldMk cId="704696398" sldId="277"/>
            <ac:spMk id="16" creationId="{01B57EFC-0E82-4BEC-B11A-1D88C10E5794}"/>
          </ac:spMkLst>
        </pc:spChg>
      </pc:sldChg>
      <pc:sldChg chg="modSp add del mod ord">
        <pc:chgData name="Grant Stewart" userId="22320dde-3ba4-4edd-a296-7e24f78054f2" providerId="ADAL" clId="{5E6E020B-B69D-D744-8D17-2736B9589B6F}" dt="2021-10-31T17:05:21.477" v="15" actId="20577"/>
        <pc:sldMkLst>
          <pc:docMk/>
          <pc:sldMk cId="1689389231" sldId="280"/>
        </pc:sldMkLst>
        <pc:spChg chg="mod">
          <ac:chgData name="Grant Stewart" userId="22320dde-3ba4-4edd-a296-7e24f78054f2" providerId="ADAL" clId="{5E6E020B-B69D-D744-8D17-2736B9589B6F}" dt="2021-10-31T17:05:21.477" v="15" actId="20577"/>
          <ac:spMkLst>
            <pc:docMk/>
            <pc:sldMk cId="1689389231" sldId="280"/>
            <ac:spMk id="4" creationId="{E6DB52BE-0A66-CD44-A40D-4CDE4B5F4DFB}"/>
          </ac:spMkLst>
        </pc:spChg>
      </pc:sldChg>
      <pc:sldChg chg="modSp mod">
        <pc:chgData name="Grant Stewart" userId="22320dde-3ba4-4edd-a296-7e24f78054f2" providerId="ADAL" clId="{5E6E020B-B69D-D744-8D17-2736B9589B6F}" dt="2021-10-31T17:05:37.779" v="23" actId="20577"/>
        <pc:sldMkLst>
          <pc:docMk/>
          <pc:sldMk cId="2580442385" sldId="281"/>
        </pc:sldMkLst>
        <pc:spChg chg="mod">
          <ac:chgData name="Grant Stewart" userId="22320dde-3ba4-4edd-a296-7e24f78054f2" providerId="ADAL" clId="{5E6E020B-B69D-D744-8D17-2736B9589B6F}" dt="2021-10-31T17:05:37.779" v="23" actId="20577"/>
          <ac:spMkLst>
            <pc:docMk/>
            <pc:sldMk cId="2580442385" sldId="281"/>
            <ac:spMk id="2" creationId="{003BF590-1C3C-C245-95AA-0F2D01D01294}"/>
          </ac:spMkLst>
        </pc:spChg>
      </pc:sldChg>
      <pc:sldChg chg="modSp mod">
        <pc:chgData name="Grant Stewart" userId="22320dde-3ba4-4edd-a296-7e24f78054f2" providerId="ADAL" clId="{5E6E020B-B69D-D744-8D17-2736B9589B6F}" dt="2021-10-31T17:05:33.398" v="21" actId="20577"/>
        <pc:sldMkLst>
          <pc:docMk/>
          <pc:sldMk cId="2128603470" sldId="282"/>
        </pc:sldMkLst>
        <pc:spChg chg="mod">
          <ac:chgData name="Grant Stewart" userId="22320dde-3ba4-4edd-a296-7e24f78054f2" providerId="ADAL" clId="{5E6E020B-B69D-D744-8D17-2736B9589B6F}" dt="2021-10-31T17:05:33.398" v="21" actId="20577"/>
          <ac:spMkLst>
            <pc:docMk/>
            <pc:sldMk cId="2128603470" sldId="282"/>
            <ac:spMk id="4" creationId="{49CA2FF4-CDDC-A74C-B37B-94133D1C1AF1}"/>
          </ac:spMkLst>
        </pc:spChg>
      </pc:sldChg>
      <pc:sldChg chg="modSp mod">
        <pc:chgData name="Grant Stewart" userId="22320dde-3ba4-4edd-a296-7e24f78054f2" providerId="ADAL" clId="{5E6E020B-B69D-D744-8D17-2736B9589B6F}" dt="2021-10-31T17:05:29.794" v="19" actId="20577"/>
        <pc:sldMkLst>
          <pc:docMk/>
          <pc:sldMk cId="3573533765" sldId="284"/>
        </pc:sldMkLst>
        <pc:spChg chg="mod">
          <ac:chgData name="Grant Stewart" userId="22320dde-3ba4-4edd-a296-7e24f78054f2" providerId="ADAL" clId="{5E6E020B-B69D-D744-8D17-2736B9589B6F}" dt="2021-10-31T17:05:29.794" v="19" actId="20577"/>
          <ac:spMkLst>
            <pc:docMk/>
            <pc:sldMk cId="3573533765" sldId="284"/>
            <ac:spMk id="2" creationId="{F606CCA8-8D96-F343-B340-0615DF12C442}"/>
          </ac:spMkLst>
        </pc:spChg>
      </pc:sldChg>
      <pc:sldChg chg="modSp mod">
        <pc:chgData name="Grant Stewart" userId="22320dde-3ba4-4edd-a296-7e24f78054f2" providerId="ADAL" clId="{5E6E020B-B69D-D744-8D17-2736B9589B6F}" dt="2021-10-31T17:05:41.819" v="25" actId="20577"/>
        <pc:sldMkLst>
          <pc:docMk/>
          <pc:sldMk cId="1038249812" sldId="290"/>
        </pc:sldMkLst>
        <pc:spChg chg="mod">
          <ac:chgData name="Grant Stewart" userId="22320dde-3ba4-4edd-a296-7e24f78054f2" providerId="ADAL" clId="{5E6E020B-B69D-D744-8D17-2736B9589B6F}" dt="2021-10-31T17:05:41.819" v="25" actId="20577"/>
          <ac:spMkLst>
            <pc:docMk/>
            <pc:sldMk cId="1038249812" sldId="290"/>
            <ac:spMk id="6" creationId="{E1843F71-58A3-43D7-BC53-B80B7428EE41}"/>
          </ac:spMkLst>
        </pc:spChg>
      </pc:sldChg>
      <pc:sldChg chg="modSp mod">
        <pc:chgData name="Grant Stewart" userId="22320dde-3ba4-4edd-a296-7e24f78054f2" providerId="ADAL" clId="{5E6E020B-B69D-D744-8D17-2736B9589B6F}" dt="2021-10-31T17:05:58.851" v="27" actId="20577"/>
        <pc:sldMkLst>
          <pc:docMk/>
          <pc:sldMk cId="848362022" sldId="292"/>
        </pc:sldMkLst>
        <pc:spChg chg="mod">
          <ac:chgData name="Grant Stewart" userId="22320dde-3ba4-4edd-a296-7e24f78054f2" providerId="ADAL" clId="{5E6E020B-B69D-D744-8D17-2736B9589B6F}" dt="2021-10-31T17:05:58.851" v="27" actId="20577"/>
          <ac:spMkLst>
            <pc:docMk/>
            <pc:sldMk cId="848362022" sldId="292"/>
            <ac:spMk id="6" creationId="{1A6250E5-41CA-4756-9BD0-C7E6A6F95FDE}"/>
          </ac:spMkLst>
        </pc:spChg>
      </pc:sldChg>
    </pc:docChg>
  </pc:docChgLst>
  <pc:docChgLst>
    <pc:chgData name="Grant Stewart" userId="22320dde-3ba4-4edd-a296-7e24f78054f2" providerId="ADAL" clId="{F1DED6F8-B2E4-5849-8767-A54A8E948B10}"/>
    <pc:docChg chg="undo redo custSel addSld modSld">
      <pc:chgData name="Grant Stewart" userId="22320dde-3ba4-4edd-a296-7e24f78054f2" providerId="ADAL" clId="{F1DED6F8-B2E4-5849-8767-A54A8E948B10}" dt="2021-10-19T17:19:47.560" v="120" actId="20577"/>
      <pc:docMkLst>
        <pc:docMk/>
      </pc:docMkLst>
      <pc:sldChg chg="addSp modSp mod">
        <pc:chgData name="Grant Stewart" userId="22320dde-3ba4-4edd-a296-7e24f78054f2" providerId="ADAL" clId="{F1DED6F8-B2E4-5849-8767-A54A8E948B10}" dt="2021-10-19T17:19:25.475" v="110" actId="20577"/>
        <pc:sldMkLst>
          <pc:docMk/>
          <pc:sldMk cId="704696398" sldId="277"/>
        </pc:sldMkLst>
        <pc:spChg chg="mod">
          <ac:chgData name="Grant Stewart" userId="22320dde-3ba4-4edd-a296-7e24f78054f2" providerId="ADAL" clId="{F1DED6F8-B2E4-5849-8767-A54A8E948B10}" dt="2021-10-08T14:44:06.319" v="25" actId="164"/>
          <ac:spMkLst>
            <pc:docMk/>
            <pc:sldMk cId="704696398" sldId="277"/>
            <ac:spMk id="7" creationId="{6057BD5C-5183-4DE3-B3CA-A404EF03E424}"/>
          </ac:spMkLst>
        </pc:spChg>
        <pc:spChg chg="mod">
          <ac:chgData name="Grant Stewart" userId="22320dde-3ba4-4edd-a296-7e24f78054f2" providerId="ADAL" clId="{F1DED6F8-B2E4-5849-8767-A54A8E948B10}" dt="2021-10-08T14:44:06.319" v="25" actId="164"/>
          <ac:spMkLst>
            <pc:docMk/>
            <pc:sldMk cId="704696398" sldId="277"/>
            <ac:spMk id="8" creationId="{C5F543A0-E3D9-4F47-879E-285EC272B74E}"/>
          </ac:spMkLst>
        </pc:spChg>
        <pc:spChg chg="mod">
          <ac:chgData name="Grant Stewart" userId="22320dde-3ba4-4edd-a296-7e24f78054f2" providerId="ADAL" clId="{F1DED6F8-B2E4-5849-8767-A54A8E948B10}" dt="2021-10-08T14:44:06.319" v="25" actId="164"/>
          <ac:spMkLst>
            <pc:docMk/>
            <pc:sldMk cId="704696398" sldId="277"/>
            <ac:spMk id="9" creationId="{CE3C2B10-F440-480D-9A48-3876C62F1CEB}"/>
          </ac:spMkLst>
        </pc:spChg>
        <pc:spChg chg="mod">
          <ac:chgData name="Grant Stewart" userId="22320dde-3ba4-4edd-a296-7e24f78054f2" providerId="ADAL" clId="{F1DED6F8-B2E4-5849-8767-A54A8E948B10}" dt="2021-10-19T17:19:25.475" v="110" actId="20577"/>
          <ac:spMkLst>
            <pc:docMk/>
            <pc:sldMk cId="704696398" sldId="277"/>
            <ac:spMk id="16" creationId="{01B57EFC-0E82-4BEC-B11A-1D88C10E5794}"/>
          </ac:spMkLst>
        </pc:spChg>
        <pc:spChg chg="mod">
          <ac:chgData name="Grant Stewart" userId="22320dde-3ba4-4edd-a296-7e24f78054f2" providerId="ADAL" clId="{F1DED6F8-B2E4-5849-8767-A54A8E948B10}" dt="2021-10-08T14:44:06.319" v="25" actId="164"/>
          <ac:spMkLst>
            <pc:docMk/>
            <pc:sldMk cId="704696398" sldId="277"/>
            <ac:spMk id="18" creationId="{4B186022-3DD0-FB49-86D6-073ECD1820DA}"/>
          </ac:spMkLst>
        </pc:spChg>
        <pc:spChg chg="mod">
          <ac:chgData name="Grant Stewart" userId="22320dde-3ba4-4edd-a296-7e24f78054f2" providerId="ADAL" clId="{F1DED6F8-B2E4-5849-8767-A54A8E948B10}" dt="2021-10-08T14:44:06.319" v="25" actId="164"/>
          <ac:spMkLst>
            <pc:docMk/>
            <pc:sldMk cId="704696398" sldId="277"/>
            <ac:spMk id="19" creationId="{F969C6DE-6BE1-0E48-A999-A2D0888BACC0}"/>
          </ac:spMkLst>
        </pc:spChg>
        <pc:grpChg chg="mod">
          <ac:chgData name="Grant Stewart" userId="22320dde-3ba4-4edd-a296-7e24f78054f2" providerId="ADAL" clId="{F1DED6F8-B2E4-5849-8767-A54A8E948B10}" dt="2021-10-08T14:44:06.319" v="25" actId="164"/>
          <ac:grpSpMkLst>
            <pc:docMk/>
            <pc:sldMk cId="704696398" sldId="277"/>
            <ac:grpSpMk id="2" creationId="{B4D9A3AB-9934-C341-BA20-C8E702BDD47B}"/>
          </ac:grpSpMkLst>
        </pc:grpChg>
        <pc:grpChg chg="mod">
          <ac:chgData name="Grant Stewart" userId="22320dde-3ba4-4edd-a296-7e24f78054f2" providerId="ADAL" clId="{F1DED6F8-B2E4-5849-8767-A54A8E948B10}" dt="2021-10-08T14:44:06.319" v="25" actId="164"/>
          <ac:grpSpMkLst>
            <pc:docMk/>
            <pc:sldMk cId="704696398" sldId="277"/>
            <ac:grpSpMk id="3" creationId="{25646966-40A6-004C-A549-FF1CEBDE9220}"/>
          </ac:grpSpMkLst>
        </pc:grpChg>
        <pc:grpChg chg="mod">
          <ac:chgData name="Grant Stewart" userId="22320dde-3ba4-4edd-a296-7e24f78054f2" providerId="ADAL" clId="{F1DED6F8-B2E4-5849-8767-A54A8E948B10}" dt="2021-10-08T14:44:06.319" v="25" actId="164"/>
          <ac:grpSpMkLst>
            <pc:docMk/>
            <pc:sldMk cId="704696398" sldId="277"/>
            <ac:grpSpMk id="17" creationId="{55098751-83FF-8943-8C66-FE4DD85BCEE1}"/>
          </ac:grpSpMkLst>
        </pc:grpChg>
        <pc:grpChg chg="mod">
          <ac:chgData name="Grant Stewart" userId="22320dde-3ba4-4edd-a296-7e24f78054f2" providerId="ADAL" clId="{F1DED6F8-B2E4-5849-8767-A54A8E948B10}" dt="2021-10-08T14:44:06.319" v="25" actId="164"/>
          <ac:grpSpMkLst>
            <pc:docMk/>
            <pc:sldMk cId="704696398" sldId="277"/>
            <ac:grpSpMk id="20" creationId="{AF5F98E1-E212-7E44-81F9-BB75728CBECD}"/>
          </ac:grpSpMkLst>
        </pc:grpChg>
        <pc:grpChg chg="mod">
          <ac:chgData name="Grant Stewart" userId="22320dde-3ba4-4edd-a296-7e24f78054f2" providerId="ADAL" clId="{F1DED6F8-B2E4-5849-8767-A54A8E948B10}" dt="2021-10-08T14:44:06.319" v="25" actId="164"/>
          <ac:grpSpMkLst>
            <pc:docMk/>
            <pc:sldMk cId="704696398" sldId="277"/>
            <ac:grpSpMk id="24" creationId="{393E02ED-C8D9-2641-BE74-4617B8581EFA}"/>
          </ac:grpSpMkLst>
        </pc:grpChg>
        <pc:grpChg chg="mod">
          <ac:chgData name="Grant Stewart" userId="22320dde-3ba4-4edd-a296-7e24f78054f2" providerId="ADAL" clId="{F1DED6F8-B2E4-5849-8767-A54A8E948B10}" dt="2021-10-08T14:44:06.319" v="25" actId="164"/>
          <ac:grpSpMkLst>
            <pc:docMk/>
            <pc:sldMk cId="704696398" sldId="277"/>
            <ac:grpSpMk id="28" creationId="{8ED2E16C-A13E-D64F-BBCA-66E3CF6FCDE2}"/>
          </ac:grpSpMkLst>
        </pc:grpChg>
        <pc:grpChg chg="add mod">
          <ac:chgData name="Grant Stewart" userId="22320dde-3ba4-4edd-a296-7e24f78054f2" providerId="ADAL" clId="{F1DED6F8-B2E4-5849-8767-A54A8E948B10}" dt="2021-10-08T14:44:35.412" v="29" actId="14100"/>
          <ac:grpSpMkLst>
            <pc:docMk/>
            <pc:sldMk cId="704696398" sldId="277"/>
            <ac:grpSpMk id="32" creationId="{06286467-3F00-C248-831B-BE5A63FC246D}"/>
          </ac:grpSpMkLst>
        </pc:grpChg>
      </pc:sldChg>
      <pc:sldChg chg="modSp add mod">
        <pc:chgData name="Grant Stewart" userId="22320dde-3ba4-4edd-a296-7e24f78054f2" providerId="ADAL" clId="{F1DED6F8-B2E4-5849-8767-A54A8E948B10}" dt="2021-10-19T17:19:21.281" v="108" actId="113"/>
        <pc:sldMkLst>
          <pc:docMk/>
          <pc:sldMk cId="1689389231" sldId="280"/>
        </pc:sldMkLst>
        <pc:spChg chg="mod">
          <ac:chgData name="Grant Stewart" userId="22320dde-3ba4-4edd-a296-7e24f78054f2" providerId="ADAL" clId="{F1DED6F8-B2E4-5849-8767-A54A8E948B10}" dt="2021-10-19T17:19:21.281" v="108" actId="113"/>
          <ac:spMkLst>
            <pc:docMk/>
            <pc:sldMk cId="1689389231" sldId="280"/>
            <ac:spMk id="4" creationId="{E6DB52BE-0A66-CD44-A40D-4CDE4B5F4DFB}"/>
          </ac:spMkLst>
        </pc:spChg>
      </pc:sldChg>
      <pc:sldChg chg="modSp mod">
        <pc:chgData name="Grant Stewart" userId="22320dde-3ba4-4edd-a296-7e24f78054f2" providerId="ADAL" clId="{F1DED6F8-B2E4-5849-8767-A54A8E948B10}" dt="2021-10-19T17:19:39.335" v="116" actId="20577"/>
        <pc:sldMkLst>
          <pc:docMk/>
          <pc:sldMk cId="2580442385" sldId="281"/>
        </pc:sldMkLst>
        <pc:spChg chg="mod">
          <ac:chgData name="Grant Stewart" userId="22320dde-3ba4-4edd-a296-7e24f78054f2" providerId="ADAL" clId="{F1DED6F8-B2E4-5849-8767-A54A8E948B10}" dt="2021-10-19T17:19:39.335" v="116" actId="20577"/>
          <ac:spMkLst>
            <pc:docMk/>
            <pc:sldMk cId="2580442385" sldId="281"/>
            <ac:spMk id="2" creationId="{003BF590-1C3C-C245-95AA-0F2D01D01294}"/>
          </ac:spMkLst>
        </pc:spChg>
        <pc:picChg chg="mod">
          <ac:chgData name="Grant Stewart" userId="22320dde-3ba4-4edd-a296-7e24f78054f2" providerId="ADAL" clId="{F1DED6F8-B2E4-5849-8767-A54A8E948B10}" dt="2021-10-08T14:46:04.073" v="63" actId="1076"/>
          <ac:picMkLst>
            <pc:docMk/>
            <pc:sldMk cId="2580442385" sldId="281"/>
            <ac:picMk id="4" creationId="{92350F19-D35C-6343-BAB2-34B5FCED6C4F}"/>
          </ac:picMkLst>
        </pc:picChg>
      </pc:sldChg>
      <pc:sldChg chg="modSp mod">
        <pc:chgData name="Grant Stewart" userId="22320dde-3ba4-4edd-a296-7e24f78054f2" providerId="ADAL" clId="{F1DED6F8-B2E4-5849-8767-A54A8E948B10}" dt="2021-10-19T17:19:34.969" v="114" actId="20577"/>
        <pc:sldMkLst>
          <pc:docMk/>
          <pc:sldMk cId="2128603470" sldId="282"/>
        </pc:sldMkLst>
        <pc:spChg chg="mod">
          <ac:chgData name="Grant Stewart" userId="22320dde-3ba4-4edd-a296-7e24f78054f2" providerId="ADAL" clId="{F1DED6F8-B2E4-5849-8767-A54A8E948B10}" dt="2021-10-08T12:45:04.793" v="9" actId="20577"/>
          <ac:spMkLst>
            <pc:docMk/>
            <pc:sldMk cId="2128603470" sldId="282"/>
            <ac:spMk id="2" creationId="{7E3BE00D-F614-4452-970F-B2F5D81A7BA4}"/>
          </ac:spMkLst>
        </pc:spChg>
        <pc:spChg chg="mod">
          <ac:chgData name="Grant Stewart" userId="22320dde-3ba4-4edd-a296-7e24f78054f2" providerId="ADAL" clId="{F1DED6F8-B2E4-5849-8767-A54A8E948B10}" dt="2021-10-08T12:45:10.213" v="11" actId="20577"/>
          <ac:spMkLst>
            <pc:docMk/>
            <pc:sldMk cId="2128603470" sldId="282"/>
            <ac:spMk id="3" creationId="{6F93DD63-6938-44B6-B436-AD7F4B8D990C}"/>
          </ac:spMkLst>
        </pc:spChg>
        <pc:spChg chg="mod">
          <ac:chgData name="Grant Stewart" userId="22320dde-3ba4-4edd-a296-7e24f78054f2" providerId="ADAL" clId="{F1DED6F8-B2E4-5849-8767-A54A8E948B10}" dt="2021-10-19T17:19:34.969" v="114" actId="20577"/>
          <ac:spMkLst>
            <pc:docMk/>
            <pc:sldMk cId="2128603470" sldId="282"/>
            <ac:spMk id="4" creationId="{49CA2FF4-CDDC-A74C-B37B-94133D1C1AF1}"/>
          </ac:spMkLst>
        </pc:spChg>
        <pc:spChg chg="mod">
          <ac:chgData name="Grant Stewart" userId="22320dde-3ba4-4edd-a296-7e24f78054f2" providerId="ADAL" clId="{F1DED6F8-B2E4-5849-8767-A54A8E948B10}" dt="2021-10-08T12:45:15.692" v="13" actId="20577"/>
          <ac:spMkLst>
            <pc:docMk/>
            <pc:sldMk cId="2128603470" sldId="282"/>
            <ac:spMk id="10" creationId="{63B7DF11-97AD-4746-8459-9EF2C92F9BE6}"/>
          </ac:spMkLst>
        </pc:spChg>
        <pc:spChg chg="mod">
          <ac:chgData name="Grant Stewart" userId="22320dde-3ba4-4edd-a296-7e24f78054f2" providerId="ADAL" clId="{F1DED6F8-B2E4-5849-8767-A54A8E948B10}" dt="2021-10-08T12:45:18.460" v="15" actId="20577"/>
          <ac:spMkLst>
            <pc:docMk/>
            <pc:sldMk cId="2128603470" sldId="282"/>
            <ac:spMk id="11" creationId="{B0FE0619-0568-421A-B8C7-7FC36C6445A8}"/>
          </ac:spMkLst>
        </pc:spChg>
        <pc:picChg chg="mod">
          <ac:chgData name="Grant Stewart" userId="22320dde-3ba4-4edd-a296-7e24f78054f2" providerId="ADAL" clId="{F1DED6F8-B2E4-5849-8767-A54A8E948B10}" dt="2021-10-08T14:45:36.926" v="47" actId="1076"/>
          <ac:picMkLst>
            <pc:docMk/>
            <pc:sldMk cId="2128603470" sldId="282"/>
            <ac:picMk id="8" creationId="{2CD5C3A8-CEA0-284E-AC9A-B3E46111C925}"/>
          </ac:picMkLst>
        </pc:picChg>
      </pc:sldChg>
      <pc:sldChg chg="modSp mod">
        <pc:chgData name="Grant Stewart" userId="22320dde-3ba4-4edd-a296-7e24f78054f2" providerId="ADAL" clId="{F1DED6F8-B2E4-5849-8767-A54A8E948B10}" dt="2021-10-19T17:19:29.243" v="112" actId="20577"/>
        <pc:sldMkLst>
          <pc:docMk/>
          <pc:sldMk cId="3573533765" sldId="284"/>
        </pc:sldMkLst>
        <pc:spChg chg="mod">
          <ac:chgData name="Grant Stewart" userId="22320dde-3ba4-4edd-a296-7e24f78054f2" providerId="ADAL" clId="{F1DED6F8-B2E4-5849-8767-A54A8E948B10}" dt="2021-10-19T17:19:29.243" v="112" actId="20577"/>
          <ac:spMkLst>
            <pc:docMk/>
            <pc:sldMk cId="3573533765" sldId="284"/>
            <ac:spMk id="2" creationId="{F606CCA8-8D96-F343-B340-0615DF12C442}"/>
          </ac:spMkLst>
        </pc:spChg>
        <pc:picChg chg="mod">
          <ac:chgData name="Grant Stewart" userId="22320dde-3ba4-4edd-a296-7e24f78054f2" providerId="ADAL" clId="{F1DED6F8-B2E4-5849-8767-A54A8E948B10}" dt="2021-10-08T14:45:20.086" v="42" actId="2085"/>
          <ac:picMkLst>
            <pc:docMk/>
            <pc:sldMk cId="3573533765" sldId="284"/>
            <ac:picMk id="4" creationId="{F2FEB712-06D6-CF42-8DAB-96BA133A7AF9}"/>
          </ac:picMkLst>
        </pc:picChg>
      </pc:sldChg>
      <pc:sldChg chg="addSp delSp modSp mod">
        <pc:chgData name="Grant Stewart" userId="22320dde-3ba4-4edd-a296-7e24f78054f2" providerId="ADAL" clId="{F1DED6F8-B2E4-5849-8767-A54A8E948B10}" dt="2021-10-19T17:19:43.688" v="118" actId="20577"/>
        <pc:sldMkLst>
          <pc:docMk/>
          <pc:sldMk cId="1038249812" sldId="290"/>
        </pc:sldMkLst>
        <pc:spChg chg="mod">
          <ac:chgData name="Grant Stewart" userId="22320dde-3ba4-4edd-a296-7e24f78054f2" providerId="ADAL" clId="{F1DED6F8-B2E4-5849-8767-A54A8E948B10}" dt="2021-10-08T14:48:16.420" v="91" actId="164"/>
          <ac:spMkLst>
            <pc:docMk/>
            <pc:sldMk cId="1038249812" sldId="290"/>
            <ac:spMk id="5" creationId="{E1BA34B0-3A08-4302-9ACE-95D6CC444D54}"/>
          </ac:spMkLst>
        </pc:spChg>
        <pc:spChg chg="mod">
          <ac:chgData name="Grant Stewart" userId="22320dde-3ba4-4edd-a296-7e24f78054f2" providerId="ADAL" clId="{F1DED6F8-B2E4-5849-8767-A54A8E948B10}" dt="2021-10-19T17:19:43.688" v="118" actId="20577"/>
          <ac:spMkLst>
            <pc:docMk/>
            <pc:sldMk cId="1038249812" sldId="290"/>
            <ac:spMk id="6" creationId="{E1843F71-58A3-43D7-BC53-B80B7428EE41}"/>
          </ac:spMkLst>
        </pc:spChg>
        <pc:spChg chg="mod">
          <ac:chgData name="Grant Stewart" userId="22320dde-3ba4-4edd-a296-7e24f78054f2" providerId="ADAL" clId="{F1DED6F8-B2E4-5849-8767-A54A8E948B10}" dt="2021-10-08T14:48:16.420" v="91" actId="164"/>
          <ac:spMkLst>
            <pc:docMk/>
            <pc:sldMk cId="1038249812" sldId="290"/>
            <ac:spMk id="8" creationId="{6AA68C95-94A2-4D7A-BD57-013CFB455A2C}"/>
          </ac:spMkLst>
        </pc:spChg>
        <pc:spChg chg="mod">
          <ac:chgData name="Grant Stewart" userId="22320dde-3ba4-4edd-a296-7e24f78054f2" providerId="ADAL" clId="{F1DED6F8-B2E4-5849-8767-A54A8E948B10}" dt="2021-10-08T14:48:16.420" v="91" actId="164"/>
          <ac:spMkLst>
            <pc:docMk/>
            <pc:sldMk cId="1038249812" sldId="290"/>
            <ac:spMk id="9" creationId="{68001EEF-2B18-4631-92B5-DDA86B56BFA9}"/>
          </ac:spMkLst>
        </pc:spChg>
        <pc:spChg chg="mod">
          <ac:chgData name="Grant Stewart" userId="22320dde-3ba4-4edd-a296-7e24f78054f2" providerId="ADAL" clId="{F1DED6F8-B2E4-5849-8767-A54A8E948B10}" dt="2021-10-08T14:48:16.420" v="91" actId="164"/>
          <ac:spMkLst>
            <pc:docMk/>
            <pc:sldMk cId="1038249812" sldId="290"/>
            <ac:spMk id="12" creationId="{7F6FD771-43E5-48E0-9560-D158C1FE5203}"/>
          </ac:spMkLst>
        </pc:spChg>
        <pc:spChg chg="mod">
          <ac:chgData name="Grant Stewart" userId="22320dde-3ba4-4edd-a296-7e24f78054f2" providerId="ADAL" clId="{F1DED6F8-B2E4-5849-8767-A54A8E948B10}" dt="2021-10-08T14:48:16.420" v="91" actId="164"/>
          <ac:spMkLst>
            <pc:docMk/>
            <pc:sldMk cId="1038249812" sldId="290"/>
            <ac:spMk id="13" creationId="{3AD1B47B-221C-45E0-AB15-25A3EAA5AE3A}"/>
          </ac:spMkLst>
        </pc:spChg>
        <pc:spChg chg="add del">
          <ac:chgData name="Grant Stewart" userId="22320dde-3ba4-4edd-a296-7e24f78054f2" providerId="ADAL" clId="{F1DED6F8-B2E4-5849-8767-A54A8E948B10}" dt="2021-10-08T14:48:15.860" v="90" actId="478"/>
          <ac:spMkLst>
            <pc:docMk/>
            <pc:sldMk cId="1038249812" sldId="290"/>
            <ac:spMk id="14" creationId="{1D0483A9-4175-4A10-821D-DCD368861FC4}"/>
          </ac:spMkLst>
        </pc:spChg>
        <pc:grpChg chg="add mod">
          <ac:chgData name="Grant Stewart" userId="22320dde-3ba4-4edd-a296-7e24f78054f2" providerId="ADAL" clId="{F1DED6F8-B2E4-5849-8767-A54A8E948B10}" dt="2021-10-08T14:48:16.919" v="92" actId="14100"/>
          <ac:grpSpMkLst>
            <pc:docMk/>
            <pc:sldMk cId="1038249812" sldId="290"/>
            <ac:grpSpMk id="7" creationId="{A534D473-32B7-4744-AC9A-3CC026371139}"/>
          </ac:grpSpMkLst>
        </pc:grpChg>
        <pc:picChg chg="mod">
          <ac:chgData name="Grant Stewart" userId="22320dde-3ba4-4edd-a296-7e24f78054f2" providerId="ADAL" clId="{F1DED6F8-B2E4-5849-8767-A54A8E948B10}" dt="2021-10-08T14:48:16.420" v="91" actId="164"/>
          <ac:picMkLst>
            <pc:docMk/>
            <pc:sldMk cId="1038249812" sldId="290"/>
            <ac:picMk id="2" creationId="{75530666-B18D-48EF-B657-D17261B9CE6C}"/>
          </ac:picMkLst>
        </pc:picChg>
        <pc:picChg chg="mod">
          <ac:chgData name="Grant Stewart" userId="22320dde-3ba4-4edd-a296-7e24f78054f2" providerId="ADAL" clId="{F1DED6F8-B2E4-5849-8767-A54A8E948B10}" dt="2021-10-08T14:48:16.420" v="91" actId="164"/>
          <ac:picMkLst>
            <pc:docMk/>
            <pc:sldMk cId="1038249812" sldId="290"/>
            <ac:picMk id="3" creationId="{95207DC9-B35D-4CFB-ADC4-E585D11C01D6}"/>
          </ac:picMkLst>
        </pc:picChg>
        <pc:picChg chg="mod">
          <ac:chgData name="Grant Stewart" userId="22320dde-3ba4-4edd-a296-7e24f78054f2" providerId="ADAL" clId="{F1DED6F8-B2E4-5849-8767-A54A8E948B10}" dt="2021-10-08T14:48:16.420" v="91" actId="164"/>
          <ac:picMkLst>
            <pc:docMk/>
            <pc:sldMk cId="1038249812" sldId="290"/>
            <ac:picMk id="4" creationId="{4F2FAE37-155B-4939-9448-9B8E1E1DBF05}"/>
          </ac:picMkLst>
        </pc:picChg>
        <pc:picChg chg="mod">
          <ac:chgData name="Grant Stewart" userId="22320dde-3ba4-4edd-a296-7e24f78054f2" providerId="ADAL" clId="{F1DED6F8-B2E4-5849-8767-A54A8E948B10}" dt="2021-10-08T14:48:16.420" v="91" actId="164"/>
          <ac:picMkLst>
            <pc:docMk/>
            <pc:sldMk cId="1038249812" sldId="290"/>
            <ac:picMk id="10" creationId="{9478BF54-5A0E-49BF-A7F2-72279B44DF47}"/>
          </ac:picMkLst>
        </pc:picChg>
        <pc:picChg chg="mod">
          <ac:chgData name="Grant Stewart" userId="22320dde-3ba4-4edd-a296-7e24f78054f2" providerId="ADAL" clId="{F1DED6F8-B2E4-5849-8767-A54A8E948B10}" dt="2021-10-08T14:48:16.420" v="91" actId="164"/>
          <ac:picMkLst>
            <pc:docMk/>
            <pc:sldMk cId="1038249812" sldId="290"/>
            <ac:picMk id="11" creationId="{3165A641-BFD4-4ED2-ADD3-AAFAC745C803}"/>
          </ac:picMkLst>
        </pc:picChg>
      </pc:sldChg>
      <pc:sldChg chg="addSp delSp modSp mod">
        <pc:chgData name="Grant Stewart" userId="22320dde-3ba4-4edd-a296-7e24f78054f2" providerId="ADAL" clId="{F1DED6F8-B2E4-5849-8767-A54A8E948B10}" dt="2021-10-19T17:19:47.560" v="120" actId="20577"/>
        <pc:sldMkLst>
          <pc:docMk/>
          <pc:sldMk cId="848362022" sldId="292"/>
        </pc:sldMkLst>
        <pc:spChg chg="mod">
          <ac:chgData name="Grant Stewart" userId="22320dde-3ba4-4edd-a296-7e24f78054f2" providerId="ADAL" clId="{F1DED6F8-B2E4-5849-8767-A54A8E948B10}" dt="2021-10-19T17:19:47.560" v="120" actId="20577"/>
          <ac:spMkLst>
            <pc:docMk/>
            <pc:sldMk cId="848362022" sldId="292"/>
            <ac:spMk id="6" creationId="{1A6250E5-41CA-4756-9BD0-C7E6A6F95FDE}"/>
          </ac:spMkLst>
        </pc:spChg>
        <pc:spChg chg="add del">
          <ac:chgData name="Grant Stewart" userId="22320dde-3ba4-4edd-a296-7e24f78054f2" providerId="ADAL" clId="{F1DED6F8-B2E4-5849-8767-A54A8E948B10}" dt="2021-10-08T14:48:21.676" v="101" actId="478"/>
          <ac:spMkLst>
            <pc:docMk/>
            <pc:sldMk cId="848362022" sldId="292"/>
            <ac:spMk id="9" creationId="{08E6327E-8051-4261-B651-4BC7A61AEBAA}"/>
          </ac:spMkLst>
        </pc:spChg>
        <pc:picChg chg="mod">
          <ac:chgData name="Grant Stewart" userId="22320dde-3ba4-4edd-a296-7e24f78054f2" providerId="ADAL" clId="{F1DED6F8-B2E4-5849-8767-A54A8E948B10}" dt="2021-10-08T14:48:21.101" v="100" actId="1076"/>
          <ac:picMkLst>
            <pc:docMk/>
            <pc:sldMk cId="848362022" sldId="292"/>
            <ac:picMk id="7" creationId="{28124CB5-3ECE-42AA-AAD6-F48C6A495728}"/>
          </ac:picMkLst>
        </pc:picChg>
      </pc:sldChg>
    </pc:docChg>
  </pc:docChgLst>
  <pc:docChgLst>
    <pc:chgData name="Grant Stewart" userId="22320dde-3ba4-4edd-a296-7e24f78054f2" providerId="ADAL" clId="{76AC5AEE-9E70-6D4D-991B-A89023398C34}"/>
    <pc:docChg chg="delSld">
      <pc:chgData name="Grant Stewart" userId="22320dde-3ba4-4edd-a296-7e24f78054f2" providerId="ADAL" clId="{76AC5AEE-9E70-6D4D-991B-A89023398C34}" dt="2021-12-22T17:44:30.991" v="0" actId="2696"/>
      <pc:docMkLst>
        <pc:docMk/>
      </pc:docMkLst>
      <pc:sldChg chg="del">
        <pc:chgData name="Grant Stewart" userId="22320dde-3ba4-4edd-a296-7e24f78054f2" providerId="ADAL" clId="{76AC5AEE-9E70-6D4D-991B-A89023398C34}" dt="2021-12-22T17:44:30.991" v="0" actId="2696"/>
        <pc:sldMkLst>
          <pc:docMk/>
          <pc:sldMk cId="848362022" sldId="292"/>
        </pc:sldMkLst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4EF73EA-1027-6A48-ABC9-D65AEDF9C72C}" type="datetimeFigureOut">
              <a:rPr lang="en-US" smtClean="0"/>
              <a:t>2/4/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935163" y="1143000"/>
            <a:ext cx="29876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3928476-35C0-4946-97F1-7321E68B66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5597709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2062083"/>
            <a:ext cx="10363200" cy="4386662"/>
          </a:xfrm>
        </p:spPr>
        <p:txBody>
          <a:bodyPr anchor="b"/>
          <a:lstStyle>
            <a:lvl1pPr algn="ctr">
              <a:defRPr sz="80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6617911"/>
            <a:ext cx="9144000" cy="3042080"/>
          </a:xfrm>
        </p:spPr>
        <p:txBody>
          <a:bodyPr/>
          <a:lstStyle>
            <a:lvl1pPr marL="0" indent="0" algn="ctr">
              <a:buNone/>
              <a:defRPr sz="3200"/>
            </a:lvl1pPr>
            <a:lvl2pPr marL="609585" indent="0" algn="ctr">
              <a:buNone/>
              <a:defRPr sz="2667"/>
            </a:lvl2pPr>
            <a:lvl3pPr marL="1219170" indent="0" algn="ctr">
              <a:buNone/>
              <a:defRPr sz="2400"/>
            </a:lvl3pPr>
            <a:lvl4pPr marL="1828754" indent="0" algn="ctr">
              <a:buNone/>
              <a:defRPr sz="2133"/>
            </a:lvl4pPr>
            <a:lvl5pPr marL="2438339" indent="0" algn="ctr">
              <a:buNone/>
              <a:defRPr sz="2133"/>
            </a:lvl5pPr>
            <a:lvl6pPr marL="3047924" indent="0" algn="ctr">
              <a:buNone/>
              <a:defRPr sz="2133"/>
            </a:lvl6pPr>
            <a:lvl7pPr marL="3657509" indent="0" algn="ctr">
              <a:buNone/>
              <a:defRPr sz="2133"/>
            </a:lvl7pPr>
            <a:lvl8pPr marL="4267093" indent="0" algn="ctr">
              <a:buNone/>
              <a:defRPr sz="2133"/>
            </a:lvl8pPr>
            <a:lvl9pPr marL="4876678" indent="0" algn="ctr">
              <a:buNone/>
              <a:defRPr sz="2133"/>
            </a:lvl9pPr>
          </a:lstStyle>
          <a:p>
            <a:r>
              <a:rPr lang="en-GB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56BC50-393E-AE40-8E68-D3D4BB10DC63}" type="datetimeFigureOut">
              <a:rPr lang="en-US" smtClean="0"/>
              <a:t>2/4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ABD5AA-2ABC-A744-9A47-912B346001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349233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56BC50-393E-AE40-8E68-D3D4BB10DC63}" type="datetimeFigureOut">
              <a:rPr lang="en-US" smtClean="0"/>
              <a:t>2/4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ABD5AA-2ABC-A744-9A47-912B346001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7857880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1" y="670833"/>
            <a:ext cx="2628900" cy="10677907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1" y="670833"/>
            <a:ext cx="7734300" cy="10677907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56BC50-393E-AE40-8E68-D3D4BB10DC63}" type="datetimeFigureOut">
              <a:rPr lang="en-US" smtClean="0"/>
              <a:t>2/4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ABD5AA-2ABC-A744-9A47-912B346001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18705461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itle 1"/>
          <p:cNvSpPr>
            <a:spLocks noGrp="1"/>
          </p:cNvSpPr>
          <p:nvPr>
            <p:ph type="title"/>
          </p:nvPr>
        </p:nvSpPr>
        <p:spPr>
          <a:xfrm>
            <a:off x="346360" y="1284592"/>
            <a:ext cx="11007441" cy="1207898"/>
          </a:xfrm>
        </p:spPr>
        <p:txBody>
          <a:bodyPr/>
          <a:lstStyle/>
          <a:p>
            <a:r>
              <a:rPr lang="en-US" dirty="0"/>
              <a:t>Click to edit Master title style</a:t>
            </a:r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3A8DDA48-6780-FF49-A170-2B322CF1C3A9}"/>
              </a:ext>
            </a:extLst>
          </p:cNvPr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r>
              <a:rPr lang="en-US"/>
              <a:t>PRESENTED BY:</a:t>
            </a:r>
            <a:r>
              <a:rPr lang="en-US" sz="1400" b="0"/>
              <a:t> Insert Name  </a:t>
            </a:r>
            <a:endParaRPr lang="en-US" sz="1400" b="0" dirty="0"/>
          </a:p>
        </p:txBody>
      </p:sp>
    </p:spTree>
    <p:extLst>
      <p:ext uri="{BB962C8B-B14F-4D97-AF65-F5344CB8AC3E}">
        <p14:creationId xmlns:p14="http://schemas.microsoft.com/office/powerpoint/2010/main" val="259660017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56BC50-393E-AE40-8E68-D3D4BB10DC63}" type="datetimeFigureOut">
              <a:rPr lang="en-US" smtClean="0"/>
              <a:t>2/4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ABD5AA-2ABC-A744-9A47-912B346001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62337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1" y="3141251"/>
            <a:ext cx="10515600" cy="5241244"/>
          </a:xfrm>
        </p:spPr>
        <p:txBody>
          <a:bodyPr anchor="b"/>
          <a:lstStyle>
            <a:lvl1pPr>
              <a:defRPr sz="80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1" y="8432079"/>
            <a:ext cx="10515600" cy="2756246"/>
          </a:xfrm>
        </p:spPr>
        <p:txBody>
          <a:bodyPr/>
          <a:lstStyle>
            <a:lvl1pPr marL="0" indent="0">
              <a:buNone/>
              <a:defRPr sz="3200">
                <a:solidFill>
                  <a:schemeClr val="tx1"/>
                </a:solidFill>
              </a:defRPr>
            </a:lvl1pPr>
            <a:lvl2pPr marL="609585" indent="0">
              <a:buNone/>
              <a:defRPr sz="2667">
                <a:solidFill>
                  <a:schemeClr val="tx1">
                    <a:tint val="75000"/>
                  </a:schemeClr>
                </a:solidFill>
              </a:defRPr>
            </a:lvl2pPr>
            <a:lvl3pPr marL="121917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3pPr>
            <a:lvl4pPr marL="182875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4pPr>
            <a:lvl5pPr marL="243833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5pPr>
            <a:lvl6pPr marL="304792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6pPr>
            <a:lvl7pPr marL="365750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7pPr>
            <a:lvl8pPr marL="4267093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8pPr>
            <a:lvl9pPr marL="4876678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56BC50-393E-AE40-8E68-D3D4BB10DC63}" type="datetimeFigureOut">
              <a:rPr lang="en-US" smtClean="0"/>
              <a:t>2/4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ABD5AA-2ABC-A744-9A47-912B346001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177660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3354163"/>
            <a:ext cx="5181600" cy="7994577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3354163"/>
            <a:ext cx="5181600" cy="7994577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56BC50-393E-AE40-8E68-D3D4BB10DC63}" type="datetimeFigureOut">
              <a:rPr lang="en-US" smtClean="0"/>
              <a:t>2/4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ABD5AA-2ABC-A744-9A47-912B346001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5946384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670836"/>
            <a:ext cx="10515600" cy="2435415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3088748"/>
            <a:ext cx="5157787" cy="1513748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4602496"/>
            <a:ext cx="5157787" cy="676957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1" y="3088748"/>
            <a:ext cx="5183188" cy="1513748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1" y="4602496"/>
            <a:ext cx="5183188" cy="676957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56BC50-393E-AE40-8E68-D3D4BB10DC63}" type="datetimeFigureOut">
              <a:rPr lang="en-US" smtClean="0"/>
              <a:t>2/4/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ABD5AA-2ABC-A744-9A47-912B346001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4860521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56BC50-393E-AE40-8E68-D3D4BB10DC63}" type="datetimeFigureOut">
              <a:rPr lang="en-US" smtClean="0"/>
              <a:t>2/4/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ABD5AA-2ABC-A744-9A47-912B346001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5947855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56BC50-393E-AE40-8E68-D3D4BB10DC63}" type="datetimeFigureOut">
              <a:rPr lang="en-US" smtClean="0"/>
              <a:t>2/4/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ABD5AA-2ABC-A744-9A47-912B346001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092812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839999"/>
            <a:ext cx="3932237" cy="2939997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1814168"/>
            <a:ext cx="6172200" cy="8954158"/>
          </a:xfrm>
        </p:spPr>
        <p:txBody>
          <a:bodyPr/>
          <a:lstStyle>
            <a:lvl1pPr>
              <a:defRPr sz="4267"/>
            </a:lvl1pPr>
            <a:lvl2pPr>
              <a:defRPr sz="3733"/>
            </a:lvl2pPr>
            <a:lvl3pPr>
              <a:defRPr sz="3200"/>
            </a:lvl3pPr>
            <a:lvl4pPr>
              <a:defRPr sz="2667"/>
            </a:lvl4pPr>
            <a:lvl5pPr>
              <a:defRPr sz="2667"/>
            </a:lvl5pPr>
            <a:lvl6pPr>
              <a:defRPr sz="2667"/>
            </a:lvl6pPr>
            <a:lvl7pPr>
              <a:defRPr sz="2667"/>
            </a:lvl7pPr>
            <a:lvl8pPr>
              <a:defRPr sz="2667"/>
            </a:lvl8pPr>
            <a:lvl9pPr>
              <a:defRPr sz="2667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3779996"/>
            <a:ext cx="3932237" cy="7002911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56BC50-393E-AE40-8E68-D3D4BB10DC63}" type="datetimeFigureOut">
              <a:rPr lang="en-US" smtClean="0"/>
              <a:t>2/4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ABD5AA-2ABC-A744-9A47-912B346001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8951528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839999"/>
            <a:ext cx="3932237" cy="2939997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1814168"/>
            <a:ext cx="6172200" cy="8954158"/>
          </a:xfrm>
        </p:spPr>
        <p:txBody>
          <a:bodyPr anchor="t"/>
          <a:lstStyle>
            <a:lvl1pPr marL="0" indent="0">
              <a:buNone/>
              <a:defRPr sz="4267"/>
            </a:lvl1pPr>
            <a:lvl2pPr marL="609585" indent="0">
              <a:buNone/>
              <a:defRPr sz="3733"/>
            </a:lvl2pPr>
            <a:lvl3pPr marL="1219170" indent="0">
              <a:buNone/>
              <a:defRPr sz="3200"/>
            </a:lvl3pPr>
            <a:lvl4pPr marL="1828754" indent="0">
              <a:buNone/>
              <a:defRPr sz="2667"/>
            </a:lvl4pPr>
            <a:lvl5pPr marL="2438339" indent="0">
              <a:buNone/>
              <a:defRPr sz="2667"/>
            </a:lvl5pPr>
            <a:lvl6pPr marL="3047924" indent="0">
              <a:buNone/>
              <a:defRPr sz="2667"/>
            </a:lvl6pPr>
            <a:lvl7pPr marL="3657509" indent="0">
              <a:buNone/>
              <a:defRPr sz="2667"/>
            </a:lvl7pPr>
            <a:lvl8pPr marL="4267093" indent="0">
              <a:buNone/>
              <a:defRPr sz="2667"/>
            </a:lvl8pPr>
            <a:lvl9pPr marL="4876678" indent="0">
              <a:buNone/>
              <a:defRPr sz="2667"/>
            </a:lvl9pPr>
          </a:lstStyle>
          <a:p>
            <a:r>
              <a:rPr lang="en-GB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3779996"/>
            <a:ext cx="3932237" cy="7002911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56BC50-393E-AE40-8E68-D3D4BB10DC63}" type="datetimeFigureOut">
              <a:rPr lang="en-US" smtClean="0"/>
              <a:t>2/4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ABD5AA-2ABC-A744-9A47-912B346001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0862833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670836"/>
            <a:ext cx="10515600" cy="243541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3354163"/>
            <a:ext cx="10515600" cy="799457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11678325"/>
            <a:ext cx="2743200" cy="670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156BC50-393E-AE40-8E68-D3D4BB10DC63}" type="datetimeFigureOut">
              <a:rPr lang="en-US" smtClean="0"/>
              <a:t>2/4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11678325"/>
            <a:ext cx="4114800" cy="670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11678325"/>
            <a:ext cx="2743200" cy="670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EABD5AA-2ABC-A744-9A47-912B346001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1353825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2" r:id="rId1"/>
    <p:sldLayoutId id="2147483663" r:id="rId2"/>
    <p:sldLayoutId id="2147483664" r:id="rId3"/>
    <p:sldLayoutId id="2147483665" r:id="rId4"/>
    <p:sldLayoutId id="2147483666" r:id="rId5"/>
    <p:sldLayoutId id="2147483667" r:id="rId6"/>
    <p:sldLayoutId id="2147483668" r:id="rId7"/>
    <p:sldLayoutId id="2147483669" r:id="rId8"/>
    <p:sldLayoutId id="2147483670" r:id="rId9"/>
    <p:sldLayoutId id="2147483671" r:id="rId10"/>
    <p:sldLayoutId id="2147483672" r:id="rId11"/>
    <p:sldLayoutId id="2147483673" r:id="rId12"/>
  </p:sldLayoutIdLst>
  <p:txStyles>
    <p:titleStyle>
      <a:lvl1pPr algn="l" defTabSz="1219170" rtl="0" eaLnBrk="1" latinLnBrk="0" hangingPunct="1">
        <a:lnSpc>
          <a:spcPct val="90000"/>
        </a:lnSpc>
        <a:spcBef>
          <a:spcPct val="0"/>
        </a:spcBef>
        <a:buNone/>
        <a:defRPr sz="586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04792" indent="-304792" algn="l" defTabSz="1219170" rtl="0" eaLnBrk="1" latinLnBrk="0" hangingPunct="1">
        <a:lnSpc>
          <a:spcPct val="90000"/>
        </a:lnSpc>
        <a:spcBef>
          <a:spcPts val="1333"/>
        </a:spcBef>
        <a:buFont typeface="Arial" panose="020B0604020202020204" pitchFamily="34" charset="0"/>
        <a:buChar char="•"/>
        <a:defRPr sz="3733" kern="1200">
          <a:solidFill>
            <a:schemeClr val="tx1"/>
          </a:solidFill>
          <a:latin typeface="+mn-lt"/>
          <a:ea typeface="+mn-ea"/>
          <a:cs typeface="+mn-cs"/>
        </a:defRPr>
      </a:lvl1pPr>
      <a:lvl2pPr marL="91437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523962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3pPr>
      <a:lvl4pPr marL="213354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74313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35271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30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57188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5181470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09585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21917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82875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3833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04792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65750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267093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876678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7" Type="http://schemas.openxmlformats.org/officeDocument/2006/relationships/image" Target="../media/image6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2.xml"/><Relationship Id="rId6" Type="http://schemas.openxmlformats.org/officeDocument/2006/relationships/image" Target="../media/image5.jpg"/><Relationship Id="rId5" Type="http://schemas.openxmlformats.org/officeDocument/2006/relationships/image" Target="../media/image4.jpg"/><Relationship Id="rId4" Type="http://schemas.openxmlformats.org/officeDocument/2006/relationships/image" Target="../media/image3.jpg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4.xml"/><Relationship Id="rId6" Type="http://schemas.openxmlformats.org/officeDocument/2006/relationships/image" Target="../media/image12.png"/><Relationship Id="rId5" Type="http://schemas.openxmlformats.org/officeDocument/2006/relationships/image" Target="../media/image11.png"/><Relationship Id="rId4" Type="http://schemas.openxmlformats.org/officeDocument/2006/relationships/image" Target="../media/image10.png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png"/><Relationship Id="rId2" Type="http://schemas.openxmlformats.org/officeDocument/2006/relationships/image" Target="../media/image14.tiff"/><Relationship Id="rId1" Type="http://schemas.openxmlformats.org/officeDocument/2006/relationships/slideLayout" Target="../slideLayouts/slideLayout4.xml"/><Relationship Id="rId6" Type="http://schemas.openxmlformats.org/officeDocument/2006/relationships/image" Target="../media/image18.png"/><Relationship Id="rId5" Type="http://schemas.openxmlformats.org/officeDocument/2006/relationships/image" Target="../media/image17.png"/><Relationship Id="rId4" Type="http://schemas.openxmlformats.org/officeDocument/2006/relationships/image" Target="../media/image16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Title 1">
            <a:extLst>
              <a:ext uri="{FF2B5EF4-FFF2-40B4-BE49-F238E27FC236}">
                <a16:creationId xmlns:a16="http://schemas.microsoft.com/office/drawing/2014/main" id="{01B57EFC-0E82-4BEC-B11A-1D88C10E579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220472" y="386502"/>
            <a:ext cx="1801396" cy="657442"/>
          </a:xfrm>
        </p:spPr>
        <p:txBody>
          <a:bodyPr>
            <a:noAutofit/>
          </a:bodyPr>
          <a:lstStyle/>
          <a:p>
            <a:r>
              <a:rPr lang="en-GB" sz="2400" b="1" dirty="0">
                <a:cs typeface="Arial Black" panose="020B0604020202020204" pitchFamily="34" charset="0"/>
              </a:rPr>
              <a:t>Figure S1</a:t>
            </a:r>
          </a:p>
        </p:txBody>
      </p:sp>
      <p:grpSp>
        <p:nvGrpSpPr>
          <p:cNvPr id="32" name="Group 31">
            <a:extLst>
              <a:ext uri="{FF2B5EF4-FFF2-40B4-BE49-F238E27FC236}">
                <a16:creationId xmlns:a16="http://schemas.microsoft.com/office/drawing/2014/main" id="{06286467-3F00-C248-831B-BE5A63FC246D}"/>
              </a:ext>
            </a:extLst>
          </p:cNvPr>
          <p:cNvGrpSpPr>
            <a:grpSpLocks noChangeAspect="1"/>
          </p:cNvGrpSpPr>
          <p:nvPr/>
        </p:nvGrpSpPr>
        <p:grpSpPr>
          <a:xfrm>
            <a:off x="2323" y="2057400"/>
            <a:ext cx="12053753" cy="7696200"/>
            <a:chOff x="1281491" y="2874136"/>
            <a:chExt cx="10574887" cy="6751959"/>
          </a:xfrm>
        </p:grpSpPr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6057BD5C-5183-4DE3-B3CA-A404EF03E424}"/>
                </a:ext>
              </a:extLst>
            </p:cNvPr>
            <p:cNvSpPr txBox="1"/>
            <p:nvPr/>
          </p:nvSpPr>
          <p:spPr>
            <a:xfrm>
              <a:off x="2676753" y="2891908"/>
              <a:ext cx="1438656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defTabSz="457200">
                <a:defRPr/>
              </a:pPr>
              <a:r>
                <a:rPr lang="en-GB" sz="2800" dirty="0">
                  <a:latin typeface="Calibri" panose="020F0502020204030204"/>
                </a:rPr>
                <a:t>Baseline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C5F543A0-E3D9-4F47-879E-285EC272B74E}"/>
                </a:ext>
              </a:extLst>
            </p:cNvPr>
            <p:cNvSpPr txBox="1"/>
            <p:nvPr/>
          </p:nvSpPr>
          <p:spPr>
            <a:xfrm>
              <a:off x="5614706" y="2895214"/>
              <a:ext cx="2755392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defTabSz="457200">
                <a:defRPr/>
              </a:pPr>
              <a:r>
                <a:rPr lang="en-GB" sz="2800" dirty="0">
                  <a:latin typeface="Calibri" panose="020F0502020204030204"/>
                </a:rPr>
                <a:t>3 week follow-up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CE3C2B10-F440-480D-9A48-3876C62F1CEB}"/>
                </a:ext>
              </a:extLst>
            </p:cNvPr>
            <p:cNvSpPr txBox="1"/>
            <p:nvPr/>
          </p:nvSpPr>
          <p:spPr>
            <a:xfrm>
              <a:off x="9100986" y="2874136"/>
              <a:ext cx="2755392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defTabSz="457200">
                <a:defRPr/>
              </a:pPr>
              <a:r>
                <a:rPr lang="en-GB" sz="2800" dirty="0">
                  <a:latin typeface="Calibri" panose="020F0502020204030204"/>
                </a:rPr>
                <a:t>9 week follow-up</a:t>
              </a:r>
            </a:p>
          </p:txBody>
        </p:sp>
        <p:grpSp>
          <p:nvGrpSpPr>
            <p:cNvPr id="2" name="Group 1">
              <a:extLst>
                <a:ext uri="{FF2B5EF4-FFF2-40B4-BE49-F238E27FC236}">
                  <a16:creationId xmlns:a16="http://schemas.microsoft.com/office/drawing/2014/main" id="{B4D9A3AB-9934-C341-BA20-C8E702BDD47B}"/>
                </a:ext>
              </a:extLst>
            </p:cNvPr>
            <p:cNvGrpSpPr>
              <a:grpSpLocks noChangeAspect="1"/>
            </p:cNvGrpSpPr>
            <p:nvPr/>
          </p:nvGrpSpPr>
          <p:grpSpPr>
            <a:xfrm>
              <a:off x="2213485" y="3481943"/>
              <a:ext cx="2339927" cy="3117467"/>
              <a:chOff x="335622" y="1743756"/>
              <a:chExt cx="3296574" cy="4392000"/>
            </a:xfrm>
          </p:grpSpPr>
          <p:pic>
            <p:nvPicPr>
              <p:cNvPr id="4" name="Picture 3" descr="A picture containing sitting, photo, person, food&#10;&#10;Description automatically generated">
                <a:extLst>
                  <a:ext uri="{FF2B5EF4-FFF2-40B4-BE49-F238E27FC236}">
                    <a16:creationId xmlns:a16="http://schemas.microsoft.com/office/drawing/2014/main" id="{5D8C89FF-59D7-45EE-A524-63D4D70CBEBB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1041" r="40830" b="44602"/>
              <a:stretch/>
            </p:blipFill>
            <p:spPr>
              <a:xfrm>
                <a:off x="335622" y="1743756"/>
                <a:ext cx="3296574" cy="4392000"/>
              </a:xfrm>
              <a:prstGeom prst="rect">
                <a:avLst/>
              </a:prstGeom>
            </p:spPr>
          </p:pic>
          <p:cxnSp>
            <p:nvCxnSpPr>
              <p:cNvPr id="10" name="Straight Arrow Connector 9">
                <a:extLst>
                  <a:ext uri="{FF2B5EF4-FFF2-40B4-BE49-F238E27FC236}">
                    <a16:creationId xmlns:a16="http://schemas.microsoft.com/office/drawing/2014/main" id="{7412FA39-BE64-4138-A221-6C12B01BC128}"/>
                  </a:ext>
                </a:extLst>
              </p:cNvPr>
              <p:cNvCxnSpPr/>
              <p:nvPr/>
            </p:nvCxnSpPr>
            <p:spPr>
              <a:xfrm flipV="1">
                <a:off x="2202426" y="2412743"/>
                <a:ext cx="599768" cy="1809135"/>
              </a:xfrm>
              <a:prstGeom prst="straightConnector1">
                <a:avLst/>
              </a:prstGeom>
              <a:ln w="38100">
                <a:solidFill>
                  <a:schemeClr val="bg1"/>
                </a:solidFill>
                <a:headEnd type="triangle"/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3" name="TextBox 12">
                <a:extLst>
                  <a:ext uri="{FF2B5EF4-FFF2-40B4-BE49-F238E27FC236}">
                    <a16:creationId xmlns:a16="http://schemas.microsoft.com/office/drawing/2014/main" id="{2C24A8A6-F7A4-4148-99B4-9B74C715B70A}"/>
                  </a:ext>
                </a:extLst>
              </p:cNvPr>
              <p:cNvSpPr txBox="1"/>
              <p:nvPr/>
            </p:nvSpPr>
            <p:spPr>
              <a:xfrm>
                <a:off x="1407353" y="2902284"/>
                <a:ext cx="1438656" cy="52032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defTabSz="457200">
                  <a:defRPr/>
                </a:pPr>
                <a:r>
                  <a:rPr lang="en-GB" b="1" dirty="0">
                    <a:solidFill>
                      <a:prstClr val="white"/>
                    </a:solidFill>
                    <a:latin typeface="Calibri" panose="020F0502020204030204"/>
                  </a:rPr>
                  <a:t>9.3 cm</a:t>
                </a:r>
                <a:endParaRPr lang="en-GB" sz="2800" b="1" dirty="0">
                  <a:solidFill>
                    <a:prstClr val="white"/>
                  </a:solidFill>
                  <a:latin typeface="Calibri" panose="020F0502020204030204"/>
                </a:endParaRPr>
              </a:p>
            </p:txBody>
          </p:sp>
        </p:grpSp>
        <p:grpSp>
          <p:nvGrpSpPr>
            <p:cNvPr id="3" name="Group 2">
              <a:extLst>
                <a:ext uri="{FF2B5EF4-FFF2-40B4-BE49-F238E27FC236}">
                  <a16:creationId xmlns:a16="http://schemas.microsoft.com/office/drawing/2014/main" id="{25646966-40A6-004C-A549-FF1CEBDE9220}"/>
                </a:ext>
              </a:extLst>
            </p:cNvPr>
            <p:cNvGrpSpPr>
              <a:grpSpLocks noChangeAspect="1"/>
            </p:cNvGrpSpPr>
            <p:nvPr/>
          </p:nvGrpSpPr>
          <p:grpSpPr>
            <a:xfrm>
              <a:off x="5789345" y="3481942"/>
              <a:ext cx="2340027" cy="3117600"/>
              <a:chOff x="4302839" y="1743756"/>
              <a:chExt cx="3296574" cy="4392000"/>
            </a:xfrm>
          </p:grpSpPr>
          <p:pic>
            <p:nvPicPr>
              <p:cNvPr id="5" name="Picture 4" descr="A picture containing dog, photo, sitting, young&#10;&#10;Description automatically generated">
                <a:extLst>
                  <a:ext uri="{FF2B5EF4-FFF2-40B4-BE49-F238E27FC236}">
                    <a16:creationId xmlns:a16="http://schemas.microsoft.com/office/drawing/2014/main" id="{32583494-4295-4513-88E5-64A731A8FF45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8910" t="6728" r="38107" b="37874"/>
              <a:stretch/>
            </p:blipFill>
            <p:spPr>
              <a:xfrm>
                <a:off x="4302839" y="1743756"/>
                <a:ext cx="3296574" cy="4392000"/>
              </a:xfrm>
              <a:prstGeom prst="rect">
                <a:avLst/>
              </a:prstGeom>
            </p:spPr>
          </p:pic>
          <p:cxnSp>
            <p:nvCxnSpPr>
              <p:cNvPr id="12" name="Straight Arrow Connector 11">
                <a:extLst>
                  <a:ext uri="{FF2B5EF4-FFF2-40B4-BE49-F238E27FC236}">
                    <a16:creationId xmlns:a16="http://schemas.microsoft.com/office/drawing/2014/main" id="{6C7D5646-854A-4AF8-8953-A4A9439C4354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6194323" y="2963349"/>
                <a:ext cx="265471" cy="1410929"/>
              </a:xfrm>
              <a:prstGeom prst="straightConnector1">
                <a:avLst/>
              </a:prstGeom>
              <a:ln w="38100">
                <a:solidFill>
                  <a:schemeClr val="bg1"/>
                </a:solidFill>
                <a:headEnd type="triangle"/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4" name="TextBox 13">
                <a:extLst>
                  <a:ext uri="{FF2B5EF4-FFF2-40B4-BE49-F238E27FC236}">
                    <a16:creationId xmlns:a16="http://schemas.microsoft.com/office/drawing/2014/main" id="{4ED3D44B-248C-4B1F-A811-9AE3CD9F78C3}"/>
                  </a:ext>
                </a:extLst>
              </p:cNvPr>
              <p:cNvSpPr txBox="1"/>
              <p:nvPr/>
            </p:nvSpPr>
            <p:spPr>
              <a:xfrm>
                <a:off x="5278350" y="3271616"/>
                <a:ext cx="1438656" cy="52030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defTabSz="457200">
                  <a:defRPr/>
                </a:pPr>
                <a:r>
                  <a:rPr lang="en-GB" b="1" dirty="0">
                    <a:solidFill>
                      <a:prstClr val="white"/>
                    </a:solidFill>
                    <a:latin typeface="Calibri" panose="020F0502020204030204"/>
                  </a:rPr>
                  <a:t>6.5 cm</a:t>
                </a:r>
                <a:endParaRPr lang="en-GB" sz="2800" b="1" dirty="0">
                  <a:solidFill>
                    <a:prstClr val="white"/>
                  </a:solidFill>
                  <a:latin typeface="Calibri" panose="020F0502020204030204"/>
                </a:endParaRPr>
              </a:p>
            </p:txBody>
          </p:sp>
        </p:grpSp>
        <p:grpSp>
          <p:nvGrpSpPr>
            <p:cNvPr id="17" name="Group 16">
              <a:extLst>
                <a:ext uri="{FF2B5EF4-FFF2-40B4-BE49-F238E27FC236}">
                  <a16:creationId xmlns:a16="http://schemas.microsoft.com/office/drawing/2014/main" id="{55098751-83FF-8943-8C66-FE4DD85BCEE1}"/>
                </a:ext>
              </a:extLst>
            </p:cNvPr>
            <p:cNvGrpSpPr>
              <a:grpSpLocks noChangeAspect="1"/>
            </p:cNvGrpSpPr>
            <p:nvPr/>
          </p:nvGrpSpPr>
          <p:grpSpPr>
            <a:xfrm>
              <a:off x="9365305" y="3481942"/>
              <a:ext cx="2340027" cy="3117600"/>
              <a:chOff x="8270056" y="1743756"/>
              <a:chExt cx="3296574" cy="4392000"/>
            </a:xfrm>
          </p:grpSpPr>
          <p:pic>
            <p:nvPicPr>
              <p:cNvPr id="6" name="Picture 5" descr="A picture containing indoor, dog, building, sitting&#10;&#10;Description automatically generated">
                <a:extLst>
                  <a:ext uri="{FF2B5EF4-FFF2-40B4-BE49-F238E27FC236}">
                    <a16:creationId xmlns:a16="http://schemas.microsoft.com/office/drawing/2014/main" id="{A87EE5F4-9141-4620-95EA-FF358202FD12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6866" t="8973" r="45005" b="35629"/>
              <a:stretch/>
            </p:blipFill>
            <p:spPr>
              <a:xfrm>
                <a:off x="8270056" y="1743756"/>
                <a:ext cx="3296574" cy="4392000"/>
              </a:xfrm>
              <a:prstGeom prst="rect">
                <a:avLst/>
              </a:prstGeom>
            </p:spPr>
          </p:pic>
          <p:cxnSp>
            <p:nvCxnSpPr>
              <p:cNvPr id="11" name="Straight Arrow Connector 10">
                <a:extLst>
                  <a:ext uri="{FF2B5EF4-FFF2-40B4-BE49-F238E27FC236}">
                    <a16:creationId xmlns:a16="http://schemas.microsoft.com/office/drawing/2014/main" id="{33BEE45A-25AB-413F-93DA-154E2EA4E18E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10210800" y="3199323"/>
                <a:ext cx="358877" cy="1106130"/>
              </a:xfrm>
              <a:prstGeom prst="straightConnector1">
                <a:avLst/>
              </a:prstGeom>
              <a:ln w="38100">
                <a:solidFill>
                  <a:schemeClr val="bg1"/>
                </a:solidFill>
                <a:headEnd type="triangle"/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5" name="TextBox 14">
                <a:extLst>
                  <a:ext uri="{FF2B5EF4-FFF2-40B4-BE49-F238E27FC236}">
                    <a16:creationId xmlns:a16="http://schemas.microsoft.com/office/drawing/2014/main" id="{4CB7F4E6-E9E7-4692-894A-8FC28FC038CC}"/>
                  </a:ext>
                </a:extLst>
              </p:cNvPr>
              <p:cNvSpPr txBox="1"/>
              <p:nvPr/>
            </p:nvSpPr>
            <p:spPr>
              <a:xfrm>
                <a:off x="9270246" y="3456282"/>
                <a:ext cx="1438656" cy="52030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defTabSz="457200">
                  <a:defRPr/>
                </a:pPr>
                <a:r>
                  <a:rPr lang="en-GB" b="1" dirty="0">
                    <a:solidFill>
                      <a:prstClr val="white"/>
                    </a:solidFill>
                    <a:latin typeface="Calibri" panose="020F0502020204030204"/>
                  </a:rPr>
                  <a:t>5.2 cm</a:t>
                </a:r>
                <a:endParaRPr lang="en-GB" sz="2800" b="1" dirty="0">
                  <a:solidFill>
                    <a:prstClr val="white"/>
                  </a:solidFill>
                  <a:latin typeface="Calibri" panose="020F0502020204030204"/>
                </a:endParaRPr>
              </a:p>
            </p:txBody>
          </p:sp>
        </p:grp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4B186022-3DD0-FB49-86D6-073ECD1820DA}"/>
                </a:ext>
              </a:extLst>
            </p:cNvPr>
            <p:cNvSpPr txBox="1"/>
            <p:nvPr/>
          </p:nvSpPr>
          <p:spPr>
            <a:xfrm>
              <a:off x="1285139" y="4304273"/>
              <a:ext cx="892777" cy="83099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4800" dirty="0"/>
                <a:t>a</a:t>
              </a:r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F969C6DE-6BE1-0E48-A999-A2D0888BACC0}"/>
                </a:ext>
              </a:extLst>
            </p:cNvPr>
            <p:cNvSpPr txBox="1"/>
            <p:nvPr/>
          </p:nvSpPr>
          <p:spPr>
            <a:xfrm>
              <a:off x="1281491" y="7277745"/>
              <a:ext cx="892777" cy="83099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4800" dirty="0"/>
                <a:t>b</a:t>
              </a:r>
            </a:p>
          </p:txBody>
        </p:sp>
        <p:grpSp>
          <p:nvGrpSpPr>
            <p:cNvPr id="20" name="Group 19">
              <a:extLst>
                <a:ext uri="{FF2B5EF4-FFF2-40B4-BE49-F238E27FC236}">
                  <a16:creationId xmlns:a16="http://schemas.microsoft.com/office/drawing/2014/main" id="{AF5F98E1-E212-7E44-81F9-BB75728CBECD}"/>
                </a:ext>
              </a:extLst>
            </p:cNvPr>
            <p:cNvGrpSpPr>
              <a:grpSpLocks noChangeAspect="1"/>
            </p:cNvGrpSpPr>
            <p:nvPr/>
          </p:nvGrpSpPr>
          <p:grpSpPr>
            <a:xfrm>
              <a:off x="2213484" y="6763320"/>
              <a:ext cx="2340000" cy="2862775"/>
              <a:chOff x="842790" y="2104092"/>
              <a:chExt cx="2628000" cy="3215116"/>
            </a:xfrm>
          </p:grpSpPr>
          <p:pic>
            <p:nvPicPr>
              <p:cNvPr id="21" name="Picture 20" descr="A picture containing sitting, photo, bed, young&#10;&#10;Description automatically generated">
                <a:extLst>
                  <a:ext uri="{FF2B5EF4-FFF2-40B4-BE49-F238E27FC236}">
                    <a16:creationId xmlns:a16="http://schemas.microsoft.com/office/drawing/2014/main" id="{F75AA9AF-D84E-5C4B-9874-F7590B9776B9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4140" t="21849" r="36847" b="33281"/>
              <a:stretch/>
            </p:blipFill>
            <p:spPr>
              <a:xfrm>
                <a:off x="842790" y="2104092"/>
                <a:ext cx="2628000" cy="3215116"/>
              </a:xfrm>
              <a:prstGeom prst="rect">
                <a:avLst/>
              </a:prstGeom>
            </p:spPr>
          </p:pic>
          <p:cxnSp>
            <p:nvCxnSpPr>
              <p:cNvPr id="22" name="Straight Arrow Connector 21">
                <a:extLst>
                  <a:ext uri="{FF2B5EF4-FFF2-40B4-BE49-F238E27FC236}">
                    <a16:creationId xmlns:a16="http://schemas.microsoft.com/office/drawing/2014/main" id="{FE8546BE-5C3F-D848-9DF3-065447C4C152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1887794" y="3175819"/>
                <a:ext cx="334296" cy="783607"/>
              </a:xfrm>
              <a:prstGeom prst="straightConnector1">
                <a:avLst/>
              </a:prstGeom>
              <a:ln w="38100">
                <a:solidFill>
                  <a:schemeClr val="bg1"/>
                </a:solidFill>
                <a:headEnd type="triangle"/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3" name="TextBox 22">
                <a:extLst>
                  <a:ext uri="{FF2B5EF4-FFF2-40B4-BE49-F238E27FC236}">
                    <a16:creationId xmlns:a16="http://schemas.microsoft.com/office/drawing/2014/main" id="{081859C0-3E95-3143-8984-773DFB5828B2}"/>
                  </a:ext>
                </a:extLst>
              </p:cNvPr>
              <p:cNvSpPr txBox="1"/>
              <p:nvPr/>
            </p:nvSpPr>
            <p:spPr>
              <a:xfrm>
                <a:off x="1014063" y="2806487"/>
                <a:ext cx="1438656" cy="4147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defTabSz="457200">
                  <a:defRPr/>
                </a:pPr>
                <a:r>
                  <a:rPr lang="en-GB" b="1" dirty="0">
                    <a:solidFill>
                      <a:prstClr val="white"/>
                    </a:solidFill>
                    <a:latin typeface="Calibri" panose="020F0502020204030204"/>
                  </a:rPr>
                  <a:t>4.8 cm</a:t>
                </a:r>
                <a:endParaRPr lang="en-GB" sz="2800" b="1" dirty="0">
                  <a:solidFill>
                    <a:prstClr val="white"/>
                  </a:solidFill>
                  <a:latin typeface="Calibri" panose="020F0502020204030204"/>
                </a:endParaRPr>
              </a:p>
            </p:txBody>
          </p:sp>
        </p:grpSp>
        <p:grpSp>
          <p:nvGrpSpPr>
            <p:cNvPr id="24" name="Group 23">
              <a:extLst>
                <a:ext uri="{FF2B5EF4-FFF2-40B4-BE49-F238E27FC236}">
                  <a16:creationId xmlns:a16="http://schemas.microsoft.com/office/drawing/2014/main" id="{393E02ED-C8D9-2641-BE74-4617B8581EFA}"/>
                </a:ext>
              </a:extLst>
            </p:cNvPr>
            <p:cNvGrpSpPr>
              <a:grpSpLocks noChangeAspect="1"/>
            </p:cNvGrpSpPr>
            <p:nvPr/>
          </p:nvGrpSpPr>
          <p:grpSpPr>
            <a:xfrm>
              <a:off x="5789344" y="6763320"/>
              <a:ext cx="2340000" cy="2862775"/>
              <a:chOff x="4699818" y="2104092"/>
              <a:chExt cx="2628000" cy="3215117"/>
            </a:xfrm>
          </p:grpSpPr>
          <p:pic>
            <p:nvPicPr>
              <p:cNvPr id="25" name="Picture 24" descr="A picture containing indoor, laying, child, photo&#10;&#10;Description automatically generated">
                <a:extLst>
                  <a:ext uri="{FF2B5EF4-FFF2-40B4-BE49-F238E27FC236}">
                    <a16:creationId xmlns:a16="http://schemas.microsoft.com/office/drawing/2014/main" id="{F04ED149-43C4-6E4B-AD81-12C4DB815C8C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6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9236" t="16972" r="32223" b="38159"/>
              <a:stretch/>
            </p:blipFill>
            <p:spPr>
              <a:xfrm>
                <a:off x="4699818" y="2104092"/>
                <a:ext cx="2628000" cy="3215117"/>
              </a:xfrm>
              <a:prstGeom prst="rect">
                <a:avLst/>
              </a:prstGeom>
            </p:spPr>
          </p:pic>
          <p:cxnSp>
            <p:nvCxnSpPr>
              <p:cNvPr id="26" name="Straight Arrow Connector 25">
                <a:extLst>
                  <a:ext uri="{FF2B5EF4-FFF2-40B4-BE49-F238E27FC236}">
                    <a16:creationId xmlns:a16="http://schemas.microsoft.com/office/drawing/2014/main" id="{C6D4E7EE-E8A6-C44F-9F8D-4446B2A19C8C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5594555" y="3667432"/>
                <a:ext cx="245806" cy="291994"/>
              </a:xfrm>
              <a:prstGeom prst="straightConnector1">
                <a:avLst/>
              </a:prstGeom>
              <a:ln w="38100">
                <a:solidFill>
                  <a:schemeClr val="bg1"/>
                </a:solidFill>
                <a:headEnd type="triangle"/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7" name="TextBox 26">
                <a:extLst>
                  <a:ext uri="{FF2B5EF4-FFF2-40B4-BE49-F238E27FC236}">
                    <a16:creationId xmlns:a16="http://schemas.microsoft.com/office/drawing/2014/main" id="{E7A10324-2415-8644-AF11-15A4D098AF61}"/>
                  </a:ext>
                </a:extLst>
              </p:cNvPr>
              <p:cNvSpPr txBox="1"/>
              <p:nvPr/>
            </p:nvSpPr>
            <p:spPr>
              <a:xfrm>
                <a:off x="4864184" y="2963803"/>
                <a:ext cx="1438656" cy="4147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defTabSz="457200">
                  <a:defRPr/>
                </a:pPr>
                <a:r>
                  <a:rPr lang="en-GB" b="1" dirty="0">
                    <a:solidFill>
                      <a:prstClr val="white"/>
                    </a:solidFill>
                    <a:latin typeface="Calibri" panose="020F0502020204030204"/>
                  </a:rPr>
                  <a:t>2.4 cm</a:t>
                </a:r>
                <a:endParaRPr lang="en-GB" sz="2800" b="1" dirty="0">
                  <a:solidFill>
                    <a:prstClr val="white"/>
                  </a:solidFill>
                  <a:latin typeface="Calibri" panose="020F0502020204030204"/>
                </a:endParaRPr>
              </a:p>
            </p:txBody>
          </p:sp>
        </p:grpSp>
        <p:grpSp>
          <p:nvGrpSpPr>
            <p:cNvPr id="28" name="Group 27">
              <a:extLst>
                <a:ext uri="{FF2B5EF4-FFF2-40B4-BE49-F238E27FC236}">
                  <a16:creationId xmlns:a16="http://schemas.microsoft.com/office/drawing/2014/main" id="{8ED2E16C-A13E-D64F-BBCA-66E3CF6FCDE2}"/>
                </a:ext>
              </a:extLst>
            </p:cNvPr>
            <p:cNvGrpSpPr>
              <a:grpSpLocks noChangeAspect="1"/>
            </p:cNvGrpSpPr>
            <p:nvPr/>
          </p:nvGrpSpPr>
          <p:grpSpPr>
            <a:xfrm>
              <a:off x="9365204" y="6763319"/>
              <a:ext cx="2340000" cy="2862775"/>
              <a:chOff x="8721212" y="2104092"/>
              <a:chExt cx="2628000" cy="3215117"/>
            </a:xfrm>
          </p:grpSpPr>
          <p:pic>
            <p:nvPicPr>
              <p:cNvPr id="29" name="Picture 28" descr="A picture containing photo, sitting, laying, covered&#10;&#10;Description automatically generated">
                <a:extLst>
                  <a:ext uri="{FF2B5EF4-FFF2-40B4-BE49-F238E27FC236}">
                    <a16:creationId xmlns:a16="http://schemas.microsoft.com/office/drawing/2014/main" id="{DCCBC24E-091A-D44D-9F9E-B56EAF54FB1C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7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3711" t="26531" r="37186" b="28599"/>
              <a:stretch/>
            </p:blipFill>
            <p:spPr>
              <a:xfrm>
                <a:off x="8721212" y="2104092"/>
                <a:ext cx="2628000" cy="3215117"/>
              </a:xfrm>
              <a:prstGeom prst="rect">
                <a:avLst/>
              </a:prstGeom>
            </p:spPr>
          </p:pic>
          <p:cxnSp>
            <p:nvCxnSpPr>
              <p:cNvPr id="30" name="Straight Arrow Connector 29">
                <a:extLst>
                  <a:ext uri="{FF2B5EF4-FFF2-40B4-BE49-F238E27FC236}">
                    <a16:creationId xmlns:a16="http://schemas.microsoft.com/office/drawing/2014/main" id="{2AB40E10-9BAD-B743-95C6-550404696B38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9704439" y="3813429"/>
                <a:ext cx="213904" cy="257126"/>
              </a:xfrm>
              <a:prstGeom prst="straightConnector1">
                <a:avLst/>
              </a:prstGeom>
              <a:ln w="38100">
                <a:solidFill>
                  <a:schemeClr val="bg1"/>
                </a:solidFill>
                <a:headEnd type="triangle"/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1" name="TextBox 30">
                <a:extLst>
                  <a:ext uri="{FF2B5EF4-FFF2-40B4-BE49-F238E27FC236}">
                    <a16:creationId xmlns:a16="http://schemas.microsoft.com/office/drawing/2014/main" id="{A6B76F4C-3461-CE4E-A14B-840A295525E1}"/>
                  </a:ext>
                </a:extLst>
              </p:cNvPr>
              <p:cNvSpPr txBox="1"/>
              <p:nvPr/>
            </p:nvSpPr>
            <p:spPr>
              <a:xfrm>
                <a:off x="9491472" y="2804999"/>
                <a:ext cx="1438656" cy="4147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defTabSz="457200">
                  <a:defRPr/>
                </a:pPr>
                <a:r>
                  <a:rPr lang="en-GB" b="1" dirty="0">
                    <a:solidFill>
                      <a:prstClr val="white"/>
                    </a:solidFill>
                    <a:latin typeface="Calibri" panose="020F0502020204030204"/>
                  </a:rPr>
                  <a:t>1.7 cm</a:t>
                </a:r>
                <a:endParaRPr lang="en-GB" sz="2800" b="1" dirty="0">
                  <a:solidFill>
                    <a:prstClr val="white"/>
                  </a:solidFill>
                  <a:latin typeface="Calibri" panose="020F0502020204030204"/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70469639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606CCA8-8D96-F343-B340-0615DF12C44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306172" y="-38099"/>
            <a:ext cx="10515600" cy="1196064"/>
          </a:xfrm>
        </p:spPr>
        <p:txBody>
          <a:bodyPr>
            <a:normAutofit/>
          </a:bodyPr>
          <a:lstStyle/>
          <a:p>
            <a:r>
              <a:rPr lang="en-US" sz="2400" b="1" dirty="0"/>
              <a:t>Figure S2</a:t>
            </a:r>
          </a:p>
        </p:txBody>
      </p:sp>
      <p:pic>
        <p:nvPicPr>
          <p:cNvPr id="4" name="Picture">
            <a:extLst>
              <a:ext uri="{FF2B5EF4-FFF2-40B4-BE49-F238E27FC236}">
                <a16:creationId xmlns:a16="http://schemas.microsoft.com/office/drawing/2014/main" id="{F2FEB712-06D6-CF42-8DAB-96BA133A7AF9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b="6250"/>
          <a:stretch/>
        </p:blipFill>
        <p:spPr bwMode="auto">
          <a:xfrm>
            <a:off x="306172" y="2085246"/>
            <a:ext cx="11676277" cy="7297673"/>
          </a:xfrm>
          <a:prstGeom prst="rect">
            <a:avLst/>
          </a:prstGeom>
          <a:noFill/>
          <a:ln w="15875"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</p:spTree>
    <p:extLst>
      <p:ext uri="{BB962C8B-B14F-4D97-AF65-F5344CB8AC3E}">
        <p14:creationId xmlns:p14="http://schemas.microsoft.com/office/powerpoint/2010/main" val="357353376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>
            <a:extLst>
              <a:ext uri="{FF2B5EF4-FFF2-40B4-BE49-F238E27FC236}">
                <a16:creationId xmlns:a16="http://schemas.microsoft.com/office/drawing/2014/main" id="{49CA2FF4-CDDC-A74C-B37B-94133D1C1AF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41134" y="163888"/>
            <a:ext cx="11527684" cy="489813"/>
          </a:xfrm>
        </p:spPr>
        <p:txBody>
          <a:bodyPr>
            <a:noAutofit/>
          </a:bodyPr>
          <a:lstStyle/>
          <a:p>
            <a:r>
              <a:rPr lang="en-US" sz="2400" b="1" dirty="0"/>
              <a:t>Figure S3</a:t>
            </a:r>
          </a:p>
        </p:txBody>
      </p:sp>
      <p:pic>
        <p:nvPicPr>
          <p:cNvPr id="8" name="Picture">
            <a:extLst>
              <a:ext uri="{FF2B5EF4-FFF2-40B4-BE49-F238E27FC236}">
                <a16:creationId xmlns:a16="http://schemas.microsoft.com/office/drawing/2014/main" id="{2CD5C3A8-CEA0-284E-AC9A-B3E46111C92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 bwMode="auto">
          <a:xfrm>
            <a:off x="526263" y="1733220"/>
            <a:ext cx="5237639" cy="6111179"/>
          </a:xfrm>
          <a:prstGeom prst="rect">
            <a:avLst/>
          </a:prstGeom>
          <a:noFill/>
          <a:ln w="9525">
            <a:noFill/>
            <a:headEnd/>
            <a:tailEnd/>
          </a:ln>
        </p:spPr>
      </p:pic>
      <p:pic>
        <p:nvPicPr>
          <p:cNvPr id="9" name="Picture">
            <a:extLst>
              <a:ext uri="{FF2B5EF4-FFF2-40B4-BE49-F238E27FC236}">
                <a16:creationId xmlns:a16="http://schemas.microsoft.com/office/drawing/2014/main" id="{F9418265-13D1-314D-B05F-B5831860B56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 bwMode="auto">
          <a:xfrm>
            <a:off x="6094700" y="1733220"/>
            <a:ext cx="5197874" cy="5505103"/>
          </a:xfrm>
          <a:prstGeom prst="rect">
            <a:avLst/>
          </a:prstGeom>
          <a:noFill/>
          <a:ln w="9525">
            <a:noFill/>
            <a:headEnd/>
            <a:tailEnd/>
          </a:ln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7E3BE00D-F614-4452-970F-B2F5D81A7BA4}"/>
              </a:ext>
            </a:extLst>
          </p:cNvPr>
          <p:cNvSpPr txBox="1"/>
          <p:nvPr/>
        </p:nvSpPr>
        <p:spPr>
          <a:xfrm>
            <a:off x="141134" y="1735807"/>
            <a:ext cx="459560" cy="369332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pPr algn="l"/>
            <a:r>
              <a:rPr lang="en-US" dirty="0"/>
              <a:t>a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6F93DD63-6938-44B6-B436-AD7F4B8D990C}"/>
              </a:ext>
            </a:extLst>
          </p:cNvPr>
          <p:cNvSpPr txBox="1"/>
          <p:nvPr/>
        </p:nvSpPr>
        <p:spPr>
          <a:xfrm>
            <a:off x="475514" y="7948510"/>
            <a:ext cx="365194" cy="369332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r>
              <a:rPr lang="en-GB" dirty="0">
                <a:latin typeface="Calibri Light"/>
                <a:cs typeface="Calibri Light"/>
              </a:rPr>
              <a:t>b</a:t>
            </a:r>
          </a:p>
        </p:txBody>
      </p:sp>
      <p:pic>
        <p:nvPicPr>
          <p:cNvPr id="6" name="Picture 6" descr="Chart&#10;&#10;Description automatically generated">
            <a:extLst>
              <a:ext uri="{FF2B5EF4-FFF2-40B4-BE49-F238E27FC236}">
                <a16:creationId xmlns:a16="http://schemas.microsoft.com/office/drawing/2014/main" id="{94BF60A8-5C59-456B-A9B0-5ACA6A99F4DB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28538" y="8022291"/>
            <a:ext cx="3216598" cy="4219202"/>
          </a:xfrm>
          <a:prstGeom prst="rect">
            <a:avLst/>
          </a:prstGeom>
        </p:spPr>
      </p:pic>
      <p:pic>
        <p:nvPicPr>
          <p:cNvPr id="7" name="Picture 9" descr="Chart, scatter chart&#10;&#10;Description automatically generated">
            <a:extLst>
              <a:ext uri="{FF2B5EF4-FFF2-40B4-BE49-F238E27FC236}">
                <a16:creationId xmlns:a16="http://schemas.microsoft.com/office/drawing/2014/main" id="{78B62A9F-3CD5-4109-8A29-1B417AB47F90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249499" y="8197358"/>
            <a:ext cx="2455055" cy="3869591"/>
          </a:xfrm>
          <a:prstGeom prst="rect">
            <a:avLst/>
          </a:prstGeom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63B7DF11-97AD-4746-8459-9EF2C92F9BE6}"/>
              </a:ext>
            </a:extLst>
          </p:cNvPr>
          <p:cNvSpPr txBox="1"/>
          <p:nvPr/>
        </p:nvSpPr>
        <p:spPr>
          <a:xfrm>
            <a:off x="3743451" y="7937569"/>
            <a:ext cx="365194" cy="369332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r>
              <a:rPr lang="en-GB" dirty="0">
                <a:latin typeface="Calibri Light"/>
                <a:cs typeface="Calibri Light"/>
              </a:rPr>
              <a:t>c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B0FE0619-0568-421A-B8C7-7FC36C6445A8}"/>
              </a:ext>
            </a:extLst>
          </p:cNvPr>
          <p:cNvSpPr txBox="1"/>
          <p:nvPr/>
        </p:nvSpPr>
        <p:spPr>
          <a:xfrm>
            <a:off x="6836598" y="7937569"/>
            <a:ext cx="365194" cy="369332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r>
              <a:rPr lang="en-GB" dirty="0">
                <a:latin typeface="Calibri Light"/>
                <a:cs typeface="Calibri Light"/>
              </a:rPr>
              <a:t>d</a:t>
            </a:r>
          </a:p>
        </p:txBody>
      </p:sp>
      <p:pic>
        <p:nvPicPr>
          <p:cNvPr id="12" name="Picture 12" descr="Chart&#10;&#10;Description automatically generated">
            <a:extLst>
              <a:ext uri="{FF2B5EF4-FFF2-40B4-BE49-F238E27FC236}">
                <a16:creationId xmlns:a16="http://schemas.microsoft.com/office/drawing/2014/main" id="{BD5B79EF-A0E7-404E-840E-E77475F15B54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6707531" y="8317842"/>
            <a:ext cx="3159979" cy="411825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2860347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03BF590-1C3C-C245-95AA-0F2D01D0129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247650" y="912020"/>
            <a:ext cx="5562600" cy="45719"/>
          </a:xfrm>
        </p:spPr>
        <p:txBody>
          <a:bodyPr>
            <a:normAutofit fontScale="90000"/>
          </a:bodyPr>
          <a:lstStyle/>
          <a:p>
            <a:r>
              <a:rPr lang="en-US" sz="2800" b="1" dirty="0"/>
              <a:t>Figure S4</a:t>
            </a:r>
            <a:br>
              <a:rPr lang="en-GB" dirty="0"/>
            </a:br>
            <a:endParaRPr lang="en-US" dirty="0"/>
          </a:p>
        </p:txBody>
      </p:sp>
      <p:pic>
        <p:nvPicPr>
          <p:cNvPr id="4" name="Picture">
            <a:extLst>
              <a:ext uri="{FF2B5EF4-FFF2-40B4-BE49-F238E27FC236}">
                <a16:creationId xmlns:a16="http://schemas.microsoft.com/office/drawing/2014/main" id="{92350F19-D35C-6343-BAB2-34B5FCED6C4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 bwMode="auto">
          <a:xfrm>
            <a:off x="1828800" y="1231500"/>
            <a:ext cx="8248650" cy="10999145"/>
          </a:xfrm>
          <a:prstGeom prst="rect">
            <a:avLst/>
          </a:prstGeom>
          <a:noFill/>
          <a:ln w="9525">
            <a:noFill/>
            <a:headEnd/>
            <a:tailEnd/>
          </a:ln>
        </p:spPr>
      </p:pic>
    </p:spTree>
    <p:extLst>
      <p:ext uri="{BB962C8B-B14F-4D97-AF65-F5344CB8AC3E}">
        <p14:creationId xmlns:p14="http://schemas.microsoft.com/office/powerpoint/2010/main" val="258044238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itle 1">
            <a:extLst>
              <a:ext uri="{FF2B5EF4-FFF2-40B4-BE49-F238E27FC236}">
                <a16:creationId xmlns:a16="http://schemas.microsoft.com/office/drawing/2014/main" id="{E1843F71-58A3-43D7-BC53-B80B7428EE4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0" y="475185"/>
            <a:ext cx="10774808" cy="657442"/>
          </a:xfrm>
        </p:spPr>
        <p:txBody>
          <a:bodyPr>
            <a:noAutofit/>
          </a:bodyPr>
          <a:lstStyle/>
          <a:p>
            <a:r>
              <a:rPr lang="en-GB" sz="2800" dirty="0">
                <a:cs typeface="Arial Black" panose="020B0604020202020204" pitchFamily="34" charset="0"/>
              </a:rPr>
              <a:t>Figure S5</a:t>
            </a:r>
            <a:endParaRPr lang="en-GB" sz="2800" b="1" dirty="0"/>
          </a:p>
        </p:txBody>
      </p:sp>
      <p:pic>
        <p:nvPicPr>
          <p:cNvPr id="2" name="Picture 2">
            <a:extLst>
              <a:ext uri="{FF2B5EF4-FFF2-40B4-BE49-F238E27FC236}">
                <a16:creationId xmlns:a16="http://schemas.microsoft.com/office/drawing/2014/main" id="{75530666-B18D-48EF-B657-D17261B9CE6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89340" y="2295308"/>
            <a:ext cx="7644874" cy="2685931"/>
          </a:xfrm>
          <a:prstGeom prst="rect">
            <a:avLst/>
          </a:prstGeom>
        </p:spPr>
      </p:pic>
      <p:pic>
        <p:nvPicPr>
          <p:cNvPr id="3" name="Picture 3" descr="Chart, box and whisker chart&#10;&#10;Description automatically generated">
            <a:extLst>
              <a:ext uri="{FF2B5EF4-FFF2-40B4-BE49-F238E27FC236}">
                <a16:creationId xmlns:a16="http://schemas.microsoft.com/office/drawing/2014/main" id="{95207DC9-B35D-4CFB-ADC4-E585D11C01D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56378" y="5284347"/>
            <a:ext cx="1472815" cy="2684009"/>
          </a:xfrm>
          <a:prstGeom prst="rect">
            <a:avLst/>
          </a:prstGeom>
        </p:spPr>
      </p:pic>
      <p:pic>
        <p:nvPicPr>
          <p:cNvPr id="4" name="Picture 4" descr="Chart&#10;&#10;Description automatically generated">
            <a:extLst>
              <a:ext uri="{FF2B5EF4-FFF2-40B4-BE49-F238E27FC236}">
                <a16:creationId xmlns:a16="http://schemas.microsoft.com/office/drawing/2014/main" id="{4F2FAE37-155B-4939-9448-9B8E1E1DBF05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314218" y="5234568"/>
            <a:ext cx="1851238" cy="2699775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E1BA34B0-3A08-4302-9ACE-95D6CC444D54}"/>
              </a:ext>
            </a:extLst>
          </p:cNvPr>
          <p:cNvSpPr txBox="1"/>
          <p:nvPr/>
        </p:nvSpPr>
        <p:spPr>
          <a:xfrm>
            <a:off x="2489" y="2171701"/>
            <a:ext cx="556189" cy="46025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a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6AA68C95-94A2-4D7A-BD57-013CFB455A2C}"/>
              </a:ext>
            </a:extLst>
          </p:cNvPr>
          <p:cNvSpPr txBox="1"/>
          <p:nvPr/>
        </p:nvSpPr>
        <p:spPr>
          <a:xfrm>
            <a:off x="182461" y="5117886"/>
            <a:ext cx="556189" cy="460258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en-US" b="1" dirty="0"/>
              <a:t>b</a:t>
            </a:r>
            <a:endParaRPr lang="en-US" b="1" dirty="0">
              <a:cs typeface="Calibri"/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68001EEF-2B18-4631-92B5-DDA86B56BFA9}"/>
              </a:ext>
            </a:extLst>
          </p:cNvPr>
          <p:cNvSpPr txBox="1"/>
          <p:nvPr/>
        </p:nvSpPr>
        <p:spPr>
          <a:xfrm>
            <a:off x="2036424" y="5117886"/>
            <a:ext cx="556189" cy="460258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en-US" b="1" dirty="0"/>
              <a:t>c</a:t>
            </a:r>
            <a:endParaRPr lang="en-US" b="1" dirty="0">
              <a:cs typeface="Calibri"/>
            </a:endParaRPr>
          </a:p>
        </p:txBody>
      </p:sp>
      <p:pic>
        <p:nvPicPr>
          <p:cNvPr id="10" name="Picture 10" descr="Chart, box and whisker chart&#10;&#10;Description automatically generated">
            <a:extLst>
              <a:ext uri="{FF2B5EF4-FFF2-40B4-BE49-F238E27FC236}">
                <a16:creationId xmlns:a16="http://schemas.microsoft.com/office/drawing/2014/main" id="{9478BF54-5A0E-49BF-A7F2-72279B44DF47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506727" y="5237442"/>
            <a:ext cx="1591948" cy="2826877"/>
          </a:xfrm>
          <a:prstGeom prst="rect">
            <a:avLst/>
          </a:prstGeom>
        </p:spPr>
      </p:pic>
      <p:pic>
        <p:nvPicPr>
          <p:cNvPr id="11" name="Picture 11" descr="Chart&#10;&#10;Description automatically generated">
            <a:extLst>
              <a:ext uri="{FF2B5EF4-FFF2-40B4-BE49-F238E27FC236}">
                <a16:creationId xmlns:a16="http://schemas.microsoft.com/office/drawing/2014/main" id="{3165A641-BFD4-4ED2-ADD3-AAFAC745C803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6357163" y="5237441"/>
            <a:ext cx="1599006" cy="2826878"/>
          </a:xfrm>
          <a:prstGeom prst="rect">
            <a:avLst/>
          </a:prstGeom>
        </p:spPr>
      </p:pic>
      <p:sp>
        <p:nvSpPr>
          <p:cNvPr id="12" name="TextBox 11">
            <a:extLst>
              <a:ext uri="{FF2B5EF4-FFF2-40B4-BE49-F238E27FC236}">
                <a16:creationId xmlns:a16="http://schemas.microsoft.com/office/drawing/2014/main" id="{7F6FD771-43E5-48E0-9560-D158C1FE5203}"/>
              </a:ext>
            </a:extLst>
          </p:cNvPr>
          <p:cNvSpPr txBox="1"/>
          <p:nvPr/>
        </p:nvSpPr>
        <p:spPr>
          <a:xfrm>
            <a:off x="4230539" y="5117886"/>
            <a:ext cx="556189" cy="460258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en-US" b="1" dirty="0">
                <a:cs typeface="Calibri"/>
              </a:rPr>
              <a:t>d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3AD1B47B-221C-45E0-AB15-25A3EAA5AE3A}"/>
              </a:ext>
            </a:extLst>
          </p:cNvPr>
          <p:cNvSpPr txBox="1"/>
          <p:nvPr/>
        </p:nvSpPr>
        <p:spPr>
          <a:xfrm>
            <a:off x="6215231" y="5117886"/>
            <a:ext cx="556189" cy="460258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en-US" b="1" dirty="0">
                <a:cs typeface="Calibri"/>
              </a:rPr>
              <a:t>e</a:t>
            </a:r>
          </a:p>
        </p:txBody>
      </p:sp>
    </p:spTree>
    <p:extLst>
      <p:ext uri="{BB962C8B-B14F-4D97-AF65-F5344CB8AC3E}">
        <p14:creationId xmlns:p14="http://schemas.microsoft.com/office/powerpoint/2010/main" val="103824981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038</TotalTime>
  <Words>41</Words>
  <Application>Microsoft Macintosh PowerPoint</Application>
  <PresentationFormat>Custom</PresentationFormat>
  <Paragraphs>25</Paragraphs>
  <Slides>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9" baseType="lpstr">
      <vt:lpstr>Arial</vt:lpstr>
      <vt:lpstr>Calibri</vt:lpstr>
      <vt:lpstr>Calibri Light</vt:lpstr>
      <vt:lpstr>Office Theme</vt:lpstr>
      <vt:lpstr>Figure S1</vt:lpstr>
      <vt:lpstr>Figure S2</vt:lpstr>
      <vt:lpstr>Figure S3</vt:lpstr>
      <vt:lpstr>Figure S4 </vt:lpstr>
      <vt:lpstr>Figure S5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igure 1. Consort diagram</dc:title>
  <dc:creator>Grant Stewart</dc:creator>
  <cp:lastModifiedBy>Grant Stewart</cp:lastModifiedBy>
  <cp:revision>390</cp:revision>
  <dcterms:created xsi:type="dcterms:W3CDTF">2021-02-07T21:44:40Z</dcterms:created>
  <dcterms:modified xsi:type="dcterms:W3CDTF">2022-02-04T15:11:50Z</dcterms:modified>
</cp:coreProperties>
</file>